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29"/>
  </p:normalViewPr>
  <p:slideViewPr>
    <p:cSldViewPr>
      <p:cViewPr varScale="1">
        <p:scale>
          <a:sx n="108" d="100"/>
          <a:sy n="108" d="100"/>
        </p:scale>
        <p:origin x="1760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14400" y="914400"/>
            <a:ext cx="7315200" cy="3657600"/>
            <a:chOff x="914400" y="914400"/>
            <a:chExt cx="7315200" cy="3657600"/>
          </a:xfrm>
        </p:grpSpPr>
        <p:sp>
          <p:nvSpPr>
            <p:cNvPr id="3" name="rc3"/>
            <p:cNvSpPr/>
            <p:nvPr/>
          </p:nvSpPr>
          <p:spPr>
            <a:xfrm>
              <a:off x="914400" y="914400"/>
              <a:ext cx="7315200" cy="36576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" name="rc4"/>
            <p:cNvSpPr/>
            <p:nvPr/>
          </p:nvSpPr>
          <p:spPr>
            <a:xfrm>
              <a:off x="914400" y="914400"/>
              <a:ext cx="7315200" cy="36575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5"/>
            <p:cNvSpPr/>
            <p:nvPr/>
          </p:nvSpPr>
          <p:spPr>
            <a:xfrm>
              <a:off x="1560072" y="1513432"/>
              <a:ext cx="6593612" cy="256648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" name="pl6"/>
            <p:cNvSpPr/>
            <p:nvPr/>
          </p:nvSpPr>
          <p:spPr>
            <a:xfrm>
              <a:off x="1859781" y="1630091"/>
              <a:ext cx="5389787" cy="2032944"/>
            </a:xfrm>
            <a:custGeom>
              <a:avLst/>
              <a:gdLst/>
              <a:ahLst/>
              <a:cxnLst/>
              <a:rect l="0" t="0" r="0" b="0"/>
              <a:pathLst>
                <a:path w="5389787" h="2032944">
                  <a:moveTo>
                    <a:pt x="0" y="0"/>
                  </a:moveTo>
                  <a:lnTo>
                    <a:pt x="620761" y="0"/>
                  </a:lnTo>
                  <a:lnTo>
                    <a:pt x="620761" y="68622"/>
                  </a:lnTo>
                  <a:lnTo>
                    <a:pt x="640468" y="68622"/>
                  </a:lnTo>
                  <a:lnTo>
                    <a:pt x="640468" y="137245"/>
                  </a:lnTo>
                  <a:lnTo>
                    <a:pt x="684808" y="137245"/>
                  </a:lnTo>
                  <a:lnTo>
                    <a:pt x="684808" y="274490"/>
                  </a:lnTo>
                  <a:lnTo>
                    <a:pt x="709441" y="274490"/>
                  </a:lnTo>
                  <a:lnTo>
                    <a:pt x="709441" y="343113"/>
                  </a:lnTo>
                  <a:lnTo>
                    <a:pt x="783342" y="343113"/>
                  </a:lnTo>
                  <a:lnTo>
                    <a:pt x="783342" y="411735"/>
                  </a:lnTo>
                  <a:lnTo>
                    <a:pt x="788268" y="411735"/>
                  </a:lnTo>
                  <a:lnTo>
                    <a:pt x="788268" y="480358"/>
                  </a:lnTo>
                  <a:lnTo>
                    <a:pt x="832608" y="480358"/>
                  </a:lnTo>
                  <a:lnTo>
                    <a:pt x="832608" y="548980"/>
                  </a:lnTo>
                  <a:lnTo>
                    <a:pt x="896655" y="548980"/>
                  </a:lnTo>
                  <a:lnTo>
                    <a:pt x="896655" y="617603"/>
                  </a:lnTo>
                  <a:lnTo>
                    <a:pt x="916362" y="617603"/>
                  </a:lnTo>
                  <a:lnTo>
                    <a:pt x="916362" y="686226"/>
                  </a:lnTo>
                  <a:lnTo>
                    <a:pt x="931142" y="686226"/>
                  </a:lnTo>
                  <a:lnTo>
                    <a:pt x="931142" y="754848"/>
                  </a:lnTo>
                  <a:lnTo>
                    <a:pt x="936069" y="754848"/>
                  </a:lnTo>
                  <a:lnTo>
                    <a:pt x="936069" y="823471"/>
                  </a:lnTo>
                  <a:lnTo>
                    <a:pt x="1241523" y="823471"/>
                  </a:lnTo>
                  <a:lnTo>
                    <a:pt x="1241523" y="960716"/>
                  </a:lnTo>
                  <a:lnTo>
                    <a:pt x="1394250" y="960716"/>
                  </a:lnTo>
                  <a:lnTo>
                    <a:pt x="1394250" y="1029339"/>
                  </a:lnTo>
                  <a:lnTo>
                    <a:pt x="1537124" y="1029339"/>
                  </a:lnTo>
                  <a:lnTo>
                    <a:pt x="1537124" y="1097961"/>
                  </a:lnTo>
                  <a:lnTo>
                    <a:pt x="1581464" y="1097961"/>
                  </a:lnTo>
                  <a:lnTo>
                    <a:pt x="1581464" y="1166584"/>
                  </a:lnTo>
                  <a:lnTo>
                    <a:pt x="1586390" y="1166584"/>
                  </a:lnTo>
                  <a:lnTo>
                    <a:pt x="1586390" y="1235207"/>
                  </a:lnTo>
                  <a:lnTo>
                    <a:pt x="1655364" y="1235207"/>
                  </a:lnTo>
                  <a:lnTo>
                    <a:pt x="1655364" y="1303829"/>
                  </a:lnTo>
                  <a:lnTo>
                    <a:pt x="1970672" y="1303829"/>
                  </a:lnTo>
                  <a:lnTo>
                    <a:pt x="1970672" y="1372452"/>
                  </a:lnTo>
                  <a:lnTo>
                    <a:pt x="2103692" y="1372452"/>
                  </a:lnTo>
                  <a:lnTo>
                    <a:pt x="2103692" y="1441074"/>
                  </a:lnTo>
                  <a:lnTo>
                    <a:pt x="2118472" y="1441074"/>
                  </a:lnTo>
                  <a:lnTo>
                    <a:pt x="2118472" y="1509697"/>
                  </a:lnTo>
                  <a:lnTo>
                    <a:pt x="2162812" y="1509697"/>
                  </a:lnTo>
                  <a:lnTo>
                    <a:pt x="2162812" y="1578320"/>
                  </a:lnTo>
                  <a:lnTo>
                    <a:pt x="2192372" y="1578320"/>
                  </a:lnTo>
                  <a:lnTo>
                    <a:pt x="2192372" y="1646942"/>
                  </a:lnTo>
                  <a:lnTo>
                    <a:pt x="2212079" y="1646942"/>
                  </a:lnTo>
                  <a:lnTo>
                    <a:pt x="2212079" y="1715565"/>
                  </a:lnTo>
                  <a:lnTo>
                    <a:pt x="2266272" y="1715565"/>
                  </a:lnTo>
                  <a:lnTo>
                    <a:pt x="2266272" y="1715565"/>
                  </a:lnTo>
                  <a:lnTo>
                    <a:pt x="3379702" y="1715565"/>
                  </a:lnTo>
                  <a:lnTo>
                    <a:pt x="3379702" y="1792765"/>
                  </a:lnTo>
                  <a:lnTo>
                    <a:pt x="3763983" y="1792765"/>
                  </a:lnTo>
                  <a:lnTo>
                    <a:pt x="3763983" y="1792765"/>
                  </a:lnTo>
                  <a:lnTo>
                    <a:pt x="4000464" y="1792765"/>
                  </a:lnTo>
                  <a:lnTo>
                    <a:pt x="4000464" y="1882832"/>
                  </a:lnTo>
                  <a:lnTo>
                    <a:pt x="4030024" y="1882832"/>
                  </a:lnTo>
                  <a:lnTo>
                    <a:pt x="4030024" y="1882832"/>
                  </a:lnTo>
                  <a:lnTo>
                    <a:pt x="4172897" y="1882832"/>
                  </a:lnTo>
                  <a:lnTo>
                    <a:pt x="4172897" y="1882832"/>
                  </a:lnTo>
                  <a:lnTo>
                    <a:pt x="4640932" y="1882832"/>
                  </a:lnTo>
                  <a:lnTo>
                    <a:pt x="4640932" y="2032944"/>
                  </a:lnTo>
                  <a:lnTo>
                    <a:pt x="5039993" y="2032944"/>
                  </a:lnTo>
                  <a:lnTo>
                    <a:pt x="5039993" y="2032944"/>
                  </a:lnTo>
                  <a:lnTo>
                    <a:pt x="5389787" y="2032944"/>
                  </a:lnTo>
                  <a:lnTo>
                    <a:pt x="5389787" y="2032944"/>
                  </a:lnTo>
                </a:path>
              </a:pathLst>
            </a:custGeom>
            <a:ln w="27101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" name="pg7"/>
            <p:cNvSpPr/>
            <p:nvPr/>
          </p:nvSpPr>
          <p:spPr>
            <a:xfrm>
              <a:off x="1859781" y="1630091"/>
              <a:ext cx="5389787" cy="2230469"/>
            </a:xfrm>
            <a:custGeom>
              <a:avLst/>
              <a:gdLst/>
              <a:ahLst/>
              <a:cxnLst/>
              <a:rect l="0" t="0" r="0" b="0"/>
              <a:pathLst>
                <a:path w="5389787" h="2230469">
                  <a:moveTo>
                    <a:pt x="0" y="0"/>
                  </a:moveTo>
                  <a:lnTo>
                    <a:pt x="620761" y="0"/>
                  </a:lnTo>
                  <a:lnTo>
                    <a:pt x="640468" y="0"/>
                  </a:lnTo>
                  <a:lnTo>
                    <a:pt x="684808" y="0"/>
                  </a:lnTo>
                  <a:lnTo>
                    <a:pt x="684808" y="5652"/>
                  </a:lnTo>
                  <a:lnTo>
                    <a:pt x="709441" y="5652"/>
                  </a:lnTo>
                  <a:lnTo>
                    <a:pt x="709441" y="45042"/>
                  </a:lnTo>
                  <a:lnTo>
                    <a:pt x="783342" y="45042"/>
                  </a:lnTo>
                  <a:lnTo>
                    <a:pt x="783342" y="88249"/>
                  </a:lnTo>
                  <a:lnTo>
                    <a:pt x="788268" y="88249"/>
                  </a:lnTo>
                  <a:lnTo>
                    <a:pt x="788268" y="134497"/>
                  </a:lnTo>
                  <a:lnTo>
                    <a:pt x="832608" y="134497"/>
                  </a:lnTo>
                  <a:lnTo>
                    <a:pt x="832608" y="183281"/>
                  </a:lnTo>
                  <a:lnTo>
                    <a:pt x="896655" y="183281"/>
                  </a:lnTo>
                  <a:lnTo>
                    <a:pt x="896655" y="234252"/>
                  </a:lnTo>
                  <a:lnTo>
                    <a:pt x="916362" y="234252"/>
                  </a:lnTo>
                  <a:lnTo>
                    <a:pt x="916362" y="287157"/>
                  </a:lnTo>
                  <a:lnTo>
                    <a:pt x="931142" y="287157"/>
                  </a:lnTo>
                  <a:lnTo>
                    <a:pt x="931142" y="341810"/>
                  </a:lnTo>
                  <a:lnTo>
                    <a:pt x="936069" y="341810"/>
                  </a:lnTo>
                  <a:lnTo>
                    <a:pt x="936069" y="398069"/>
                  </a:lnTo>
                  <a:lnTo>
                    <a:pt x="1241523" y="398069"/>
                  </a:lnTo>
                  <a:lnTo>
                    <a:pt x="1241523" y="515006"/>
                  </a:lnTo>
                  <a:lnTo>
                    <a:pt x="1394250" y="515006"/>
                  </a:lnTo>
                  <a:lnTo>
                    <a:pt x="1394250" y="575539"/>
                  </a:lnTo>
                  <a:lnTo>
                    <a:pt x="1537124" y="575539"/>
                  </a:lnTo>
                  <a:lnTo>
                    <a:pt x="1537124" y="637383"/>
                  </a:lnTo>
                  <a:lnTo>
                    <a:pt x="1581464" y="637383"/>
                  </a:lnTo>
                  <a:lnTo>
                    <a:pt x="1581464" y="700507"/>
                  </a:lnTo>
                  <a:lnTo>
                    <a:pt x="1586390" y="700507"/>
                  </a:lnTo>
                  <a:lnTo>
                    <a:pt x="1586390" y="764893"/>
                  </a:lnTo>
                  <a:lnTo>
                    <a:pt x="1655364" y="764893"/>
                  </a:lnTo>
                  <a:lnTo>
                    <a:pt x="1655364" y="830534"/>
                  </a:lnTo>
                  <a:lnTo>
                    <a:pt x="1970672" y="830534"/>
                  </a:lnTo>
                  <a:lnTo>
                    <a:pt x="1970672" y="897432"/>
                  </a:lnTo>
                  <a:lnTo>
                    <a:pt x="2103692" y="897432"/>
                  </a:lnTo>
                  <a:lnTo>
                    <a:pt x="2103692" y="965604"/>
                  </a:lnTo>
                  <a:lnTo>
                    <a:pt x="2118472" y="965604"/>
                  </a:lnTo>
                  <a:lnTo>
                    <a:pt x="2118472" y="1035074"/>
                  </a:lnTo>
                  <a:lnTo>
                    <a:pt x="2162812" y="1035074"/>
                  </a:lnTo>
                  <a:lnTo>
                    <a:pt x="2162812" y="1105880"/>
                  </a:lnTo>
                  <a:lnTo>
                    <a:pt x="2192372" y="1105880"/>
                  </a:lnTo>
                  <a:lnTo>
                    <a:pt x="2192372" y="1178072"/>
                  </a:lnTo>
                  <a:lnTo>
                    <a:pt x="2212079" y="1178072"/>
                  </a:lnTo>
                  <a:lnTo>
                    <a:pt x="2212079" y="1251711"/>
                  </a:lnTo>
                  <a:lnTo>
                    <a:pt x="2266272" y="1251711"/>
                  </a:lnTo>
                  <a:lnTo>
                    <a:pt x="3379702" y="1251711"/>
                  </a:lnTo>
                  <a:lnTo>
                    <a:pt x="3379702" y="1330185"/>
                  </a:lnTo>
                  <a:lnTo>
                    <a:pt x="3763983" y="1330185"/>
                  </a:lnTo>
                  <a:lnTo>
                    <a:pt x="4000464" y="1330185"/>
                  </a:lnTo>
                  <a:lnTo>
                    <a:pt x="4000464" y="1413070"/>
                  </a:lnTo>
                  <a:lnTo>
                    <a:pt x="4030024" y="1413070"/>
                  </a:lnTo>
                  <a:lnTo>
                    <a:pt x="4172897" y="1413070"/>
                  </a:lnTo>
                  <a:lnTo>
                    <a:pt x="4640932" y="1413070"/>
                  </a:lnTo>
                  <a:lnTo>
                    <a:pt x="4640932" y="1455515"/>
                  </a:lnTo>
                  <a:lnTo>
                    <a:pt x="5039993" y="1455515"/>
                  </a:lnTo>
                  <a:lnTo>
                    <a:pt x="5389787" y="1455515"/>
                  </a:lnTo>
                  <a:lnTo>
                    <a:pt x="5389787" y="2230469"/>
                  </a:lnTo>
                  <a:lnTo>
                    <a:pt x="5039993" y="2230469"/>
                  </a:lnTo>
                  <a:lnTo>
                    <a:pt x="4640932" y="2230469"/>
                  </a:lnTo>
                  <a:lnTo>
                    <a:pt x="4640932" y="2112754"/>
                  </a:lnTo>
                  <a:lnTo>
                    <a:pt x="4172897" y="2112754"/>
                  </a:lnTo>
                  <a:lnTo>
                    <a:pt x="4030024" y="2112754"/>
                  </a:lnTo>
                  <a:lnTo>
                    <a:pt x="4000464" y="2112754"/>
                  </a:lnTo>
                  <a:lnTo>
                    <a:pt x="4000464" y="2042002"/>
                  </a:lnTo>
                  <a:lnTo>
                    <a:pt x="3763983" y="2042002"/>
                  </a:lnTo>
                  <a:lnTo>
                    <a:pt x="3379702" y="2042002"/>
                  </a:lnTo>
                  <a:lnTo>
                    <a:pt x="3379702" y="1980465"/>
                  </a:lnTo>
                  <a:lnTo>
                    <a:pt x="2266272" y="1980465"/>
                  </a:lnTo>
                  <a:lnTo>
                    <a:pt x="2212079" y="1980465"/>
                  </a:lnTo>
                  <a:lnTo>
                    <a:pt x="2212079" y="1925491"/>
                  </a:lnTo>
                  <a:lnTo>
                    <a:pt x="2192372" y="1925491"/>
                  </a:lnTo>
                  <a:lnTo>
                    <a:pt x="2192372" y="1868895"/>
                  </a:lnTo>
                  <a:lnTo>
                    <a:pt x="2162812" y="1868895"/>
                  </a:lnTo>
                  <a:lnTo>
                    <a:pt x="2162812" y="1810783"/>
                  </a:lnTo>
                  <a:lnTo>
                    <a:pt x="2118472" y="1810783"/>
                  </a:lnTo>
                  <a:lnTo>
                    <a:pt x="2118472" y="1751235"/>
                  </a:lnTo>
                  <a:lnTo>
                    <a:pt x="2103692" y="1751235"/>
                  </a:lnTo>
                  <a:lnTo>
                    <a:pt x="2103692" y="1690309"/>
                  </a:lnTo>
                  <a:lnTo>
                    <a:pt x="1970672" y="1690309"/>
                  </a:lnTo>
                  <a:lnTo>
                    <a:pt x="1970672" y="1628047"/>
                  </a:lnTo>
                  <a:lnTo>
                    <a:pt x="1655364" y="1628047"/>
                  </a:lnTo>
                  <a:lnTo>
                    <a:pt x="1655364" y="1564477"/>
                  </a:lnTo>
                  <a:lnTo>
                    <a:pt x="1586390" y="1564477"/>
                  </a:lnTo>
                  <a:lnTo>
                    <a:pt x="1586390" y="1499609"/>
                  </a:lnTo>
                  <a:lnTo>
                    <a:pt x="1581464" y="1499609"/>
                  </a:lnTo>
                  <a:lnTo>
                    <a:pt x="1581464" y="1433446"/>
                  </a:lnTo>
                  <a:lnTo>
                    <a:pt x="1537124" y="1433446"/>
                  </a:lnTo>
                  <a:lnTo>
                    <a:pt x="1537124" y="1365973"/>
                  </a:lnTo>
                  <a:lnTo>
                    <a:pt x="1394250" y="1365973"/>
                  </a:lnTo>
                  <a:lnTo>
                    <a:pt x="1394250" y="1297164"/>
                  </a:lnTo>
                  <a:lnTo>
                    <a:pt x="1241523" y="1297164"/>
                  </a:lnTo>
                  <a:lnTo>
                    <a:pt x="1241523" y="1155354"/>
                  </a:lnTo>
                  <a:lnTo>
                    <a:pt x="936069" y="1155354"/>
                  </a:lnTo>
                  <a:lnTo>
                    <a:pt x="936069" y="1082216"/>
                  </a:lnTo>
                  <a:lnTo>
                    <a:pt x="931142" y="1082216"/>
                  </a:lnTo>
                  <a:lnTo>
                    <a:pt x="931142" y="1007457"/>
                  </a:lnTo>
                  <a:lnTo>
                    <a:pt x="916362" y="1007457"/>
                  </a:lnTo>
                  <a:lnTo>
                    <a:pt x="916362" y="930938"/>
                  </a:lnTo>
                  <a:lnTo>
                    <a:pt x="896655" y="930938"/>
                  </a:lnTo>
                  <a:lnTo>
                    <a:pt x="896655" y="852474"/>
                  </a:lnTo>
                  <a:lnTo>
                    <a:pt x="832608" y="852474"/>
                  </a:lnTo>
                  <a:lnTo>
                    <a:pt x="832608" y="771813"/>
                  </a:lnTo>
                  <a:lnTo>
                    <a:pt x="788268" y="771813"/>
                  </a:lnTo>
                  <a:lnTo>
                    <a:pt x="788268" y="688608"/>
                  </a:lnTo>
                  <a:lnTo>
                    <a:pt x="783342" y="688608"/>
                  </a:lnTo>
                  <a:lnTo>
                    <a:pt x="783342" y="602354"/>
                  </a:lnTo>
                  <a:lnTo>
                    <a:pt x="709441" y="602354"/>
                  </a:lnTo>
                  <a:lnTo>
                    <a:pt x="709441" y="512276"/>
                  </a:lnTo>
                  <a:lnTo>
                    <a:pt x="684808" y="512276"/>
                  </a:lnTo>
                  <a:lnTo>
                    <a:pt x="684808" y="314234"/>
                  </a:lnTo>
                  <a:lnTo>
                    <a:pt x="640468" y="314234"/>
                  </a:lnTo>
                  <a:lnTo>
                    <a:pt x="640468" y="197325"/>
                  </a:lnTo>
                  <a:lnTo>
                    <a:pt x="620761" y="197325"/>
                  </a:lnTo>
                  <a:lnTo>
                    <a:pt x="620761" y="0"/>
                  </a:lnTo>
                  <a:close/>
                </a:path>
              </a:pathLst>
            </a:custGeom>
            <a:solidFill>
              <a:srgbClr val="BEBEBE">
                <a:alpha val="29803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8" name="pl8"/>
            <p:cNvSpPr/>
            <p:nvPr/>
          </p:nvSpPr>
          <p:spPr>
            <a:xfrm>
              <a:off x="1859781" y="1630091"/>
              <a:ext cx="5389787" cy="1455515"/>
            </a:xfrm>
            <a:custGeom>
              <a:avLst/>
              <a:gdLst/>
              <a:ahLst/>
              <a:cxnLst/>
              <a:rect l="0" t="0" r="0" b="0"/>
              <a:pathLst>
                <a:path w="5389787" h="1455515">
                  <a:moveTo>
                    <a:pt x="0" y="0"/>
                  </a:moveTo>
                  <a:lnTo>
                    <a:pt x="620761" y="0"/>
                  </a:lnTo>
                  <a:lnTo>
                    <a:pt x="620761" y="0"/>
                  </a:lnTo>
                  <a:lnTo>
                    <a:pt x="640468" y="0"/>
                  </a:lnTo>
                  <a:lnTo>
                    <a:pt x="640468" y="0"/>
                  </a:lnTo>
                  <a:lnTo>
                    <a:pt x="684808" y="0"/>
                  </a:lnTo>
                  <a:lnTo>
                    <a:pt x="684808" y="5652"/>
                  </a:lnTo>
                  <a:lnTo>
                    <a:pt x="709441" y="5652"/>
                  </a:lnTo>
                  <a:lnTo>
                    <a:pt x="709441" y="45042"/>
                  </a:lnTo>
                  <a:lnTo>
                    <a:pt x="783342" y="45042"/>
                  </a:lnTo>
                  <a:lnTo>
                    <a:pt x="783342" y="88249"/>
                  </a:lnTo>
                  <a:lnTo>
                    <a:pt x="788268" y="88249"/>
                  </a:lnTo>
                  <a:lnTo>
                    <a:pt x="788268" y="134497"/>
                  </a:lnTo>
                  <a:lnTo>
                    <a:pt x="832608" y="134497"/>
                  </a:lnTo>
                  <a:lnTo>
                    <a:pt x="832608" y="183281"/>
                  </a:lnTo>
                  <a:lnTo>
                    <a:pt x="896655" y="183281"/>
                  </a:lnTo>
                  <a:lnTo>
                    <a:pt x="896655" y="234252"/>
                  </a:lnTo>
                  <a:lnTo>
                    <a:pt x="916362" y="234252"/>
                  </a:lnTo>
                  <a:lnTo>
                    <a:pt x="916362" y="287157"/>
                  </a:lnTo>
                  <a:lnTo>
                    <a:pt x="931142" y="287157"/>
                  </a:lnTo>
                  <a:lnTo>
                    <a:pt x="931142" y="341810"/>
                  </a:lnTo>
                  <a:lnTo>
                    <a:pt x="936069" y="341810"/>
                  </a:lnTo>
                  <a:lnTo>
                    <a:pt x="936069" y="398069"/>
                  </a:lnTo>
                  <a:lnTo>
                    <a:pt x="1241523" y="398069"/>
                  </a:lnTo>
                  <a:lnTo>
                    <a:pt x="1241523" y="515006"/>
                  </a:lnTo>
                  <a:lnTo>
                    <a:pt x="1394250" y="515006"/>
                  </a:lnTo>
                  <a:lnTo>
                    <a:pt x="1394250" y="575539"/>
                  </a:lnTo>
                  <a:lnTo>
                    <a:pt x="1537124" y="575539"/>
                  </a:lnTo>
                  <a:lnTo>
                    <a:pt x="1537124" y="637383"/>
                  </a:lnTo>
                  <a:lnTo>
                    <a:pt x="1581464" y="637383"/>
                  </a:lnTo>
                  <a:lnTo>
                    <a:pt x="1581464" y="700507"/>
                  </a:lnTo>
                  <a:lnTo>
                    <a:pt x="1586390" y="700507"/>
                  </a:lnTo>
                  <a:lnTo>
                    <a:pt x="1586390" y="764893"/>
                  </a:lnTo>
                  <a:lnTo>
                    <a:pt x="1655364" y="764893"/>
                  </a:lnTo>
                  <a:lnTo>
                    <a:pt x="1655364" y="830534"/>
                  </a:lnTo>
                  <a:lnTo>
                    <a:pt x="1970672" y="830534"/>
                  </a:lnTo>
                  <a:lnTo>
                    <a:pt x="1970672" y="897432"/>
                  </a:lnTo>
                  <a:lnTo>
                    <a:pt x="2103692" y="897432"/>
                  </a:lnTo>
                  <a:lnTo>
                    <a:pt x="2103692" y="965604"/>
                  </a:lnTo>
                  <a:lnTo>
                    <a:pt x="2118472" y="965604"/>
                  </a:lnTo>
                  <a:lnTo>
                    <a:pt x="2118472" y="1035074"/>
                  </a:lnTo>
                  <a:lnTo>
                    <a:pt x="2162812" y="1035074"/>
                  </a:lnTo>
                  <a:lnTo>
                    <a:pt x="2162812" y="1105880"/>
                  </a:lnTo>
                  <a:lnTo>
                    <a:pt x="2192372" y="1105880"/>
                  </a:lnTo>
                  <a:lnTo>
                    <a:pt x="2192372" y="1178072"/>
                  </a:lnTo>
                  <a:lnTo>
                    <a:pt x="2212079" y="1178072"/>
                  </a:lnTo>
                  <a:lnTo>
                    <a:pt x="2212079" y="1251711"/>
                  </a:lnTo>
                  <a:lnTo>
                    <a:pt x="2266272" y="1251711"/>
                  </a:lnTo>
                  <a:lnTo>
                    <a:pt x="2266272" y="1251711"/>
                  </a:lnTo>
                  <a:lnTo>
                    <a:pt x="3379702" y="1251711"/>
                  </a:lnTo>
                  <a:lnTo>
                    <a:pt x="3379702" y="1330185"/>
                  </a:lnTo>
                  <a:lnTo>
                    <a:pt x="3763983" y="1330185"/>
                  </a:lnTo>
                  <a:lnTo>
                    <a:pt x="3763983" y="1330185"/>
                  </a:lnTo>
                  <a:lnTo>
                    <a:pt x="4000464" y="1330185"/>
                  </a:lnTo>
                  <a:lnTo>
                    <a:pt x="4000464" y="1413070"/>
                  </a:lnTo>
                  <a:lnTo>
                    <a:pt x="4030024" y="1413070"/>
                  </a:lnTo>
                  <a:lnTo>
                    <a:pt x="4030024" y="1413070"/>
                  </a:lnTo>
                  <a:lnTo>
                    <a:pt x="4172897" y="1413070"/>
                  </a:lnTo>
                  <a:lnTo>
                    <a:pt x="4172897" y="1413070"/>
                  </a:lnTo>
                  <a:lnTo>
                    <a:pt x="4640932" y="1413070"/>
                  </a:lnTo>
                  <a:lnTo>
                    <a:pt x="4640932" y="1455515"/>
                  </a:lnTo>
                  <a:lnTo>
                    <a:pt x="5039993" y="1455515"/>
                  </a:lnTo>
                  <a:lnTo>
                    <a:pt x="5039993" y="1455515"/>
                  </a:lnTo>
                  <a:lnTo>
                    <a:pt x="5389787" y="1455515"/>
                  </a:lnTo>
                  <a:lnTo>
                    <a:pt x="5389787" y="1455515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9" name="pl9"/>
            <p:cNvSpPr/>
            <p:nvPr/>
          </p:nvSpPr>
          <p:spPr>
            <a:xfrm>
              <a:off x="1859781" y="1630091"/>
              <a:ext cx="5389787" cy="2230469"/>
            </a:xfrm>
            <a:custGeom>
              <a:avLst/>
              <a:gdLst/>
              <a:ahLst/>
              <a:cxnLst/>
              <a:rect l="0" t="0" r="0" b="0"/>
              <a:pathLst>
                <a:path w="5389787" h="2230469">
                  <a:moveTo>
                    <a:pt x="5389787" y="2230469"/>
                  </a:moveTo>
                  <a:lnTo>
                    <a:pt x="5389787" y="2230469"/>
                  </a:lnTo>
                  <a:lnTo>
                    <a:pt x="5039993" y="2230469"/>
                  </a:lnTo>
                  <a:lnTo>
                    <a:pt x="5039993" y="2230469"/>
                  </a:lnTo>
                  <a:lnTo>
                    <a:pt x="4640932" y="2230469"/>
                  </a:lnTo>
                  <a:lnTo>
                    <a:pt x="4640932" y="2112754"/>
                  </a:lnTo>
                  <a:lnTo>
                    <a:pt x="4172897" y="2112754"/>
                  </a:lnTo>
                  <a:lnTo>
                    <a:pt x="4172897" y="2112754"/>
                  </a:lnTo>
                  <a:lnTo>
                    <a:pt x="4030024" y="2112754"/>
                  </a:lnTo>
                  <a:lnTo>
                    <a:pt x="4030024" y="2112754"/>
                  </a:lnTo>
                  <a:lnTo>
                    <a:pt x="4000464" y="2112754"/>
                  </a:lnTo>
                  <a:lnTo>
                    <a:pt x="4000464" y="2042002"/>
                  </a:lnTo>
                  <a:lnTo>
                    <a:pt x="3763983" y="2042002"/>
                  </a:lnTo>
                  <a:lnTo>
                    <a:pt x="3763983" y="2042002"/>
                  </a:lnTo>
                  <a:lnTo>
                    <a:pt x="3379702" y="2042002"/>
                  </a:lnTo>
                  <a:lnTo>
                    <a:pt x="3379702" y="1980465"/>
                  </a:lnTo>
                  <a:lnTo>
                    <a:pt x="2266272" y="1980465"/>
                  </a:lnTo>
                  <a:lnTo>
                    <a:pt x="2266272" y="1980465"/>
                  </a:lnTo>
                  <a:lnTo>
                    <a:pt x="2212079" y="1980465"/>
                  </a:lnTo>
                  <a:lnTo>
                    <a:pt x="2212079" y="1925491"/>
                  </a:lnTo>
                  <a:lnTo>
                    <a:pt x="2192372" y="1925491"/>
                  </a:lnTo>
                  <a:lnTo>
                    <a:pt x="2192372" y="1868895"/>
                  </a:lnTo>
                  <a:lnTo>
                    <a:pt x="2162812" y="1868895"/>
                  </a:lnTo>
                  <a:lnTo>
                    <a:pt x="2162812" y="1810783"/>
                  </a:lnTo>
                  <a:lnTo>
                    <a:pt x="2118472" y="1810783"/>
                  </a:lnTo>
                  <a:lnTo>
                    <a:pt x="2118472" y="1751235"/>
                  </a:lnTo>
                  <a:lnTo>
                    <a:pt x="2103692" y="1751235"/>
                  </a:lnTo>
                  <a:lnTo>
                    <a:pt x="2103692" y="1690309"/>
                  </a:lnTo>
                  <a:lnTo>
                    <a:pt x="1970672" y="1690309"/>
                  </a:lnTo>
                  <a:lnTo>
                    <a:pt x="1970672" y="1628047"/>
                  </a:lnTo>
                  <a:lnTo>
                    <a:pt x="1655364" y="1628047"/>
                  </a:lnTo>
                  <a:lnTo>
                    <a:pt x="1655364" y="1564477"/>
                  </a:lnTo>
                  <a:lnTo>
                    <a:pt x="1586390" y="1564477"/>
                  </a:lnTo>
                  <a:lnTo>
                    <a:pt x="1586390" y="1499609"/>
                  </a:lnTo>
                  <a:lnTo>
                    <a:pt x="1581464" y="1499609"/>
                  </a:lnTo>
                  <a:lnTo>
                    <a:pt x="1581464" y="1433446"/>
                  </a:lnTo>
                  <a:lnTo>
                    <a:pt x="1537124" y="1433446"/>
                  </a:lnTo>
                  <a:lnTo>
                    <a:pt x="1537124" y="1365973"/>
                  </a:lnTo>
                  <a:lnTo>
                    <a:pt x="1394250" y="1365973"/>
                  </a:lnTo>
                  <a:lnTo>
                    <a:pt x="1394250" y="1297164"/>
                  </a:lnTo>
                  <a:lnTo>
                    <a:pt x="1241523" y="1297164"/>
                  </a:lnTo>
                  <a:lnTo>
                    <a:pt x="1241523" y="1155354"/>
                  </a:lnTo>
                  <a:lnTo>
                    <a:pt x="936069" y="1155354"/>
                  </a:lnTo>
                  <a:lnTo>
                    <a:pt x="936069" y="1082216"/>
                  </a:lnTo>
                  <a:lnTo>
                    <a:pt x="931142" y="1082216"/>
                  </a:lnTo>
                  <a:lnTo>
                    <a:pt x="931142" y="1007457"/>
                  </a:lnTo>
                  <a:lnTo>
                    <a:pt x="916362" y="1007457"/>
                  </a:lnTo>
                  <a:lnTo>
                    <a:pt x="916362" y="930938"/>
                  </a:lnTo>
                  <a:lnTo>
                    <a:pt x="896655" y="930938"/>
                  </a:lnTo>
                  <a:lnTo>
                    <a:pt x="896655" y="852474"/>
                  </a:lnTo>
                  <a:lnTo>
                    <a:pt x="832608" y="852474"/>
                  </a:lnTo>
                  <a:lnTo>
                    <a:pt x="832608" y="771813"/>
                  </a:lnTo>
                  <a:lnTo>
                    <a:pt x="788268" y="771813"/>
                  </a:lnTo>
                  <a:lnTo>
                    <a:pt x="788268" y="688608"/>
                  </a:lnTo>
                  <a:lnTo>
                    <a:pt x="783342" y="688608"/>
                  </a:lnTo>
                  <a:lnTo>
                    <a:pt x="783342" y="602354"/>
                  </a:lnTo>
                  <a:lnTo>
                    <a:pt x="709441" y="602354"/>
                  </a:lnTo>
                  <a:lnTo>
                    <a:pt x="709441" y="512276"/>
                  </a:lnTo>
                  <a:lnTo>
                    <a:pt x="684808" y="512276"/>
                  </a:lnTo>
                  <a:lnTo>
                    <a:pt x="684808" y="314234"/>
                  </a:lnTo>
                  <a:lnTo>
                    <a:pt x="640468" y="314234"/>
                  </a:lnTo>
                  <a:lnTo>
                    <a:pt x="640468" y="197325"/>
                  </a:lnTo>
                  <a:lnTo>
                    <a:pt x="620761" y="197325"/>
                  </a:lnTo>
                  <a:lnTo>
                    <a:pt x="620761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10" name="tx10"/>
            <p:cNvSpPr/>
            <p:nvPr/>
          </p:nvSpPr>
          <p:spPr>
            <a:xfrm>
              <a:off x="4075070" y="3301109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1" name="tx11"/>
            <p:cNvSpPr/>
            <p:nvPr/>
          </p:nvSpPr>
          <p:spPr>
            <a:xfrm>
              <a:off x="5572781" y="3378309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2" name="tx12"/>
            <p:cNvSpPr/>
            <p:nvPr/>
          </p:nvSpPr>
          <p:spPr>
            <a:xfrm>
              <a:off x="5838822" y="3468376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3" name="tx13"/>
            <p:cNvSpPr/>
            <p:nvPr/>
          </p:nvSpPr>
          <p:spPr>
            <a:xfrm>
              <a:off x="5981695" y="3468376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4" name="tx14"/>
            <p:cNvSpPr/>
            <p:nvPr/>
          </p:nvSpPr>
          <p:spPr>
            <a:xfrm>
              <a:off x="6848791" y="3618488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5" name="tx15"/>
            <p:cNvSpPr/>
            <p:nvPr/>
          </p:nvSpPr>
          <p:spPr>
            <a:xfrm>
              <a:off x="7198585" y="3618488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6" name="pl16"/>
            <p:cNvSpPr/>
            <p:nvPr/>
          </p:nvSpPr>
          <p:spPr>
            <a:xfrm>
              <a:off x="1859781" y="2796675"/>
              <a:ext cx="1583927" cy="0"/>
            </a:xfrm>
            <a:custGeom>
              <a:avLst/>
              <a:gdLst/>
              <a:ahLst/>
              <a:cxnLst/>
              <a:rect l="0" t="0" r="0" b="0"/>
              <a:pathLst>
                <a:path w="1583927">
                  <a:moveTo>
                    <a:pt x="0" y="0"/>
                  </a:moveTo>
                  <a:lnTo>
                    <a:pt x="1583927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7"/>
            <p:cNvSpPr/>
            <p:nvPr/>
          </p:nvSpPr>
          <p:spPr>
            <a:xfrm>
              <a:off x="3443709" y="2796675"/>
              <a:ext cx="0" cy="1166584"/>
            </a:xfrm>
            <a:custGeom>
              <a:avLst/>
              <a:gdLst/>
              <a:ahLst/>
              <a:cxnLst/>
              <a:rect l="0" t="0" r="0" b="0"/>
              <a:pathLst>
                <a:path h="1166584">
                  <a:moveTo>
                    <a:pt x="0" y="116658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8"/>
            <p:cNvSpPr/>
            <p:nvPr/>
          </p:nvSpPr>
          <p:spPr>
            <a:xfrm>
              <a:off x="1560072" y="1513432"/>
              <a:ext cx="0" cy="2566485"/>
            </a:xfrm>
            <a:custGeom>
              <a:avLst/>
              <a:gdLst/>
              <a:ahLst/>
              <a:cxnLst/>
              <a:rect l="0" t="0" r="0" b="0"/>
              <a:pathLst>
                <a:path h="2566485">
                  <a:moveTo>
                    <a:pt x="0" y="2566485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tx19"/>
            <p:cNvSpPr/>
            <p:nvPr/>
          </p:nvSpPr>
          <p:spPr>
            <a:xfrm>
              <a:off x="1195134" y="3908453"/>
              <a:ext cx="296614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.00</a:t>
              </a:r>
            </a:p>
          </p:txBody>
        </p:sp>
        <p:sp>
          <p:nvSpPr>
            <p:cNvPr id="20" name="tx20"/>
            <p:cNvSpPr/>
            <p:nvPr/>
          </p:nvSpPr>
          <p:spPr>
            <a:xfrm>
              <a:off x="1195134" y="3324789"/>
              <a:ext cx="296614" cy="10983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.25</a:t>
              </a:r>
            </a:p>
          </p:txBody>
        </p:sp>
        <p:sp>
          <p:nvSpPr>
            <p:cNvPr id="21" name="tx21"/>
            <p:cNvSpPr/>
            <p:nvPr/>
          </p:nvSpPr>
          <p:spPr>
            <a:xfrm>
              <a:off x="1195134" y="2741869"/>
              <a:ext cx="296614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.50</a:t>
              </a:r>
            </a:p>
          </p:txBody>
        </p:sp>
        <p:sp>
          <p:nvSpPr>
            <p:cNvPr id="22" name="tx22"/>
            <p:cNvSpPr/>
            <p:nvPr/>
          </p:nvSpPr>
          <p:spPr>
            <a:xfrm>
              <a:off x="1195134" y="2158577"/>
              <a:ext cx="296614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.75</a:t>
              </a:r>
            </a:p>
          </p:txBody>
        </p:sp>
        <p:sp>
          <p:nvSpPr>
            <p:cNvPr id="23" name="tx23"/>
            <p:cNvSpPr/>
            <p:nvPr/>
          </p:nvSpPr>
          <p:spPr>
            <a:xfrm>
              <a:off x="1195134" y="1575285"/>
              <a:ext cx="296614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1.00</a:t>
              </a:r>
            </a:p>
          </p:txBody>
        </p:sp>
        <p:sp>
          <p:nvSpPr>
            <p:cNvPr id="24" name="pl24"/>
            <p:cNvSpPr/>
            <p:nvPr/>
          </p:nvSpPr>
          <p:spPr>
            <a:xfrm>
              <a:off x="1522114" y="3963259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5"/>
            <p:cNvSpPr/>
            <p:nvPr/>
          </p:nvSpPr>
          <p:spPr>
            <a:xfrm>
              <a:off x="1522114" y="3379967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6"/>
            <p:cNvSpPr/>
            <p:nvPr/>
          </p:nvSpPr>
          <p:spPr>
            <a:xfrm>
              <a:off x="1522114" y="2796675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7"/>
            <p:cNvSpPr/>
            <p:nvPr/>
          </p:nvSpPr>
          <p:spPr>
            <a:xfrm>
              <a:off x="1522114" y="2213383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8"/>
            <p:cNvSpPr/>
            <p:nvPr/>
          </p:nvSpPr>
          <p:spPr>
            <a:xfrm>
              <a:off x="1522114" y="1630091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9"/>
            <p:cNvSpPr/>
            <p:nvPr/>
          </p:nvSpPr>
          <p:spPr>
            <a:xfrm>
              <a:off x="1560072" y="4079918"/>
              <a:ext cx="6593612" cy="0"/>
            </a:xfrm>
            <a:custGeom>
              <a:avLst/>
              <a:gdLst/>
              <a:ahLst/>
              <a:cxnLst/>
              <a:rect l="0" t="0" r="0" b="0"/>
              <a:pathLst>
                <a:path w="6593612">
                  <a:moveTo>
                    <a:pt x="0" y="0"/>
                  </a:moveTo>
                  <a:lnTo>
                    <a:pt x="6593612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30"/>
            <p:cNvSpPr/>
            <p:nvPr/>
          </p:nvSpPr>
          <p:spPr>
            <a:xfrm>
              <a:off x="1859781" y="40799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1"/>
            <p:cNvSpPr/>
            <p:nvPr/>
          </p:nvSpPr>
          <p:spPr>
            <a:xfrm>
              <a:off x="3358330" y="40799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2"/>
            <p:cNvSpPr/>
            <p:nvPr/>
          </p:nvSpPr>
          <p:spPr>
            <a:xfrm>
              <a:off x="4856878" y="40799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3"/>
            <p:cNvSpPr/>
            <p:nvPr/>
          </p:nvSpPr>
          <p:spPr>
            <a:xfrm>
              <a:off x="6355426" y="40799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4"/>
            <p:cNvSpPr/>
            <p:nvPr/>
          </p:nvSpPr>
          <p:spPr>
            <a:xfrm>
              <a:off x="7853975" y="40799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tx35"/>
            <p:cNvSpPr/>
            <p:nvPr/>
          </p:nvSpPr>
          <p:spPr>
            <a:xfrm>
              <a:off x="1817403" y="4148093"/>
              <a:ext cx="84757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</a:t>
              </a:r>
            </a:p>
          </p:txBody>
        </p:sp>
        <p:sp>
          <p:nvSpPr>
            <p:cNvPr id="36" name="tx36"/>
            <p:cNvSpPr/>
            <p:nvPr/>
          </p:nvSpPr>
          <p:spPr>
            <a:xfrm>
              <a:off x="3273572" y="4148093"/>
              <a:ext cx="169515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10</a:t>
              </a:r>
            </a:p>
          </p:txBody>
        </p:sp>
        <p:sp>
          <p:nvSpPr>
            <p:cNvPr id="37" name="tx37"/>
            <p:cNvSpPr/>
            <p:nvPr/>
          </p:nvSpPr>
          <p:spPr>
            <a:xfrm>
              <a:off x="4772120" y="4147721"/>
              <a:ext cx="169515" cy="10983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20</a:t>
              </a:r>
            </a:p>
          </p:txBody>
        </p:sp>
        <p:sp>
          <p:nvSpPr>
            <p:cNvPr id="38" name="tx38"/>
            <p:cNvSpPr/>
            <p:nvPr/>
          </p:nvSpPr>
          <p:spPr>
            <a:xfrm>
              <a:off x="6270669" y="4147944"/>
              <a:ext cx="169515" cy="1096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30</a:t>
              </a:r>
            </a:p>
          </p:txBody>
        </p:sp>
        <p:sp>
          <p:nvSpPr>
            <p:cNvPr id="39" name="tx39"/>
            <p:cNvSpPr/>
            <p:nvPr/>
          </p:nvSpPr>
          <p:spPr>
            <a:xfrm>
              <a:off x="7769217" y="4147795"/>
              <a:ext cx="169515" cy="1097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40</a:t>
              </a:r>
            </a:p>
          </p:txBody>
        </p:sp>
        <p:sp>
          <p:nvSpPr>
            <p:cNvPr id="40" name="tx40"/>
            <p:cNvSpPr/>
            <p:nvPr/>
          </p:nvSpPr>
          <p:spPr>
            <a:xfrm>
              <a:off x="4609799" y="4325403"/>
              <a:ext cx="494158" cy="13135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Month</a:t>
              </a:r>
            </a:p>
          </p:txBody>
        </p:sp>
        <p:sp>
          <p:nvSpPr>
            <p:cNvPr id="41" name="tx41"/>
            <p:cNvSpPr/>
            <p:nvPr/>
          </p:nvSpPr>
          <p:spPr>
            <a:xfrm rot="-5400000">
              <a:off x="371270" y="2712116"/>
              <a:ext cx="1324037" cy="16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PFS (probability)</a:t>
              </a:r>
            </a:p>
          </p:txBody>
        </p:sp>
        <p:sp>
          <p:nvSpPr>
            <p:cNvPr id="42" name="rc42"/>
            <p:cNvSpPr/>
            <p:nvPr/>
          </p:nvSpPr>
          <p:spPr>
            <a:xfrm>
              <a:off x="4332640" y="990315"/>
              <a:ext cx="1048476" cy="37128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l43"/>
            <p:cNvSpPr/>
            <p:nvPr/>
          </p:nvSpPr>
          <p:spPr>
            <a:xfrm>
              <a:off x="4493764" y="1175958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7101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" name="tx44"/>
            <p:cNvSpPr/>
            <p:nvPr/>
          </p:nvSpPr>
          <p:spPr>
            <a:xfrm>
              <a:off x="4530562" y="113141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45" name="tx45"/>
            <p:cNvSpPr/>
            <p:nvPr/>
          </p:nvSpPr>
          <p:spPr>
            <a:xfrm>
              <a:off x="4754537" y="1125388"/>
              <a:ext cx="550664" cy="96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Censored</a:t>
              </a: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1188720" y="4572000"/>
            <a:ext cx="7040880" cy="1828800"/>
            <a:chOff x="1188720" y="4572000"/>
            <a:chExt cx="7040880" cy="1828800"/>
          </a:xfrm>
        </p:grpSpPr>
        <p:sp>
          <p:nvSpPr>
            <p:cNvPr id="47" name="rc3"/>
            <p:cNvSpPr/>
            <p:nvPr/>
          </p:nvSpPr>
          <p:spPr>
            <a:xfrm>
              <a:off x="1188720" y="4572000"/>
              <a:ext cx="7040880" cy="1828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" name="rc4"/>
            <p:cNvSpPr/>
            <p:nvPr/>
          </p:nvSpPr>
          <p:spPr>
            <a:xfrm>
              <a:off x="1188720" y="4572000"/>
              <a:ext cx="7040880" cy="1828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" name="rc5"/>
            <p:cNvSpPr/>
            <p:nvPr/>
          </p:nvSpPr>
          <p:spPr>
            <a:xfrm>
              <a:off x="1537777" y="4914529"/>
              <a:ext cx="6615906" cy="994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50" name="tx6"/>
            <p:cNvSpPr/>
            <p:nvPr/>
          </p:nvSpPr>
          <p:spPr>
            <a:xfrm>
              <a:off x="1626110" y="5318211"/>
              <a:ext cx="424780" cy="15172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8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34 (0)</a:t>
              </a:r>
            </a:p>
          </p:txBody>
        </p:sp>
        <p:sp>
          <p:nvSpPr>
            <p:cNvPr id="51" name="tx7"/>
            <p:cNvSpPr/>
            <p:nvPr/>
          </p:nvSpPr>
          <p:spPr>
            <a:xfrm>
              <a:off x="3129725" y="5318211"/>
              <a:ext cx="424780" cy="15172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8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19 (0)</a:t>
              </a:r>
            </a:p>
          </p:txBody>
        </p:sp>
        <p:sp>
          <p:nvSpPr>
            <p:cNvPr id="52" name="tx8"/>
            <p:cNvSpPr/>
            <p:nvPr/>
          </p:nvSpPr>
          <p:spPr>
            <a:xfrm>
              <a:off x="4678558" y="5318211"/>
              <a:ext cx="334345" cy="15172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8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8 (1)</a:t>
              </a:r>
            </a:p>
          </p:txBody>
        </p:sp>
        <p:sp>
          <p:nvSpPr>
            <p:cNvPr id="53" name="tx9"/>
            <p:cNvSpPr/>
            <p:nvPr/>
          </p:nvSpPr>
          <p:spPr>
            <a:xfrm>
              <a:off x="6182173" y="5318211"/>
              <a:ext cx="334345" cy="15172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8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3 (4)</a:t>
              </a:r>
            </a:p>
          </p:txBody>
        </p:sp>
        <p:sp>
          <p:nvSpPr>
            <p:cNvPr id="54" name="tx10"/>
            <p:cNvSpPr/>
            <p:nvPr/>
          </p:nvSpPr>
          <p:spPr>
            <a:xfrm>
              <a:off x="7685788" y="5318211"/>
              <a:ext cx="334345" cy="15172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8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 (6)</a:t>
              </a:r>
            </a:p>
          </p:txBody>
        </p:sp>
        <p:sp>
          <p:nvSpPr>
            <p:cNvPr id="55" name="pl11"/>
            <p:cNvSpPr/>
            <p:nvPr/>
          </p:nvSpPr>
          <p:spPr>
            <a:xfrm>
              <a:off x="1537777" y="4914529"/>
              <a:ext cx="0" cy="994189"/>
            </a:xfrm>
            <a:custGeom>
              <a:avLst/>
              <a:gdLst/>
              <a:ahLst/>
              <a:cxnLst/>
              <a:rect l="0" t="0" r="0" b="0"/>
              <a:pathLst>
                <a:path h="994189">
                  <a:moveTo>
                    <a:pt x="0" y="994189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6" name="pl12"/>
            <p:cNvSpPr/>
            <p:nvPr/>
          </p:nvSpPr>
          <p:spPr>
            <a:xfrm>
              <a:off x="1499820" y="5411623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7" name="pl13"/>
            <p:cNvSpPr/>
            <p:nvPr/>
          </p:nvSpPr>
          <p:spPr>
            <a:xfrm>
              <a:off x="1537777" y="5908718"/>
              <a:ext cx="6615906" cy="0"/>
            </a:xfrm>
            <a:custGeom>
              <a:avLst/>
              <a:gdLst/>
              <a:ahLst/>
              <a:cxnLst/>
              <a:rect l="0" t="0" r="0" b="0"/>
              <a:pathLst>
                <a:path w="6615906">
                  <a:moveTo>
                    <a:pt x="0" y="0"/>
                  </a:moveTo>
                  <a:lnTo>
                    <a:pt x="6615906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" name="pl14"/>
            <p:cNvSpPr/>
            <p:nvPr/>
          </p:nvSpPr>
          <p:spPr>
            <a:xfrm>
              <a:off x="1838500" y="59087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pl15"/>
            <p:cNvSpPr/>
            <p:nvPr/>
          </p:nvSpPr>
          <p:spPr>
            <a:xfrm>
              <a:off x="3342116" y="59087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0" name="pl16"/>
            <p:cNvSpPr/>
            <p:nvPr/>
          </p:nvSpPr>
          <p:spPr>
            <a:xfrm>
              <a:off x="4845731" y="59087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17"/>
            <p:cNvSpPr/>
            <p:nvPr/>
          </p:nvSpPr>
          <p:spPr>
            <a:xfrm>
              <a:off x="6349346" y="59087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18"/>
            <p:cNvSpPr/>
            <p:nvPr/>
          </p:nvSpPr>
          <p:spPr>
            <a:xfrm>
              <a:off x="7852961" y="59087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tx19"/>
            <p:cNvSpPr/>
            <p:nvPr/>
          </p:nvSpPr>
          <p:spPr>
            <a:xfrm>
              <a:off x="1796122" y="5976893"/>
              <a:ext cx="84757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</a:t>
              </a:r>
            </a:p>
          </p:txBody>
        </p:sp>
        <p:sp>
          <p:nvSpPr>
            <p:cNvPr id="64" name="tx20"/>
            <p:cNvSpPr/>
            <p:nvPr/>
          </p:nvSpPr>
          <p:spPr>
            <a:xfrm>
              <a:off x="3257358" y="5976893"/>
              <a:ext cx="169515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10</a:t>
              </a:r>
            </a:p>
          </p:txBody>
        </p:sp>
        <p:sp>
          <p:nvSpPr>
            <p:cNvPr id="65" name="tx21"/>
            <p:cNvSpPr/>
            <p:nvPr/>
          </p:nvSpPr>
          <p:spPr>
            <a:xfrm>
              <a:off x="4760973" y="5976521"/>
              <a:ext cx="169515" cy="10983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20</a:t>
              </a:r>
            </a:p>
          </p:txBody>
        </p:sp>
        <p:sp>
          <p:nvSpPr>
            <p:cNvPr id="66" name="tx22"/>
            <p:cNvSpPr/>
            <p:nvPr/>
          </p:nvSpPr>
          <p:spPr>
            <a:xfrm>
              <a:off x="6264588" y="5976744"/>
              <a:ext cx="169515" cy="1096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30</a:t>
              </a:r>
            </a:p>
          </p:txBody>
        </p:sp>
        <p:sp>
          <p:nvSpPr>
            <p:cNvPr id="67" name="tx23"/>
            <p:cNvSpPr/>
            <p:nvPr/>
          </p:nvSpPr>
          <p:spPr>
            <a:xfrm>
              <a:off x="7768204" y="5976595"/>
              <a:ext cx="169515" cy="1097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40</a:t>
              </a:r>
            </a:p>
          </p:txBody>
        </p:sp>
        <p:sp>
          <p:nvSpPr>
            <p:cNvPr id="68" name="tx24"/>
            <p:cNvSpPr/>
            <p:nvPr/>
          </p:nvSpPr>
          <p:spPr>
            <a:xfrm>
              <a:off x="4598651" y="6154203"/>
              <a:ext cx="494158" cy="13135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Month</a:t>
              </a:r>
            </a:p>
          </p:txBody>
        </p:sp>
        <p:sp>
          <p:nvSpPr>
            <p:cNvPr id="69" name="tx25"/>
            <p:cNvSpPr/>
            <p:nvPr/>
          </p:nvSpPr>
          <p:spPr>
            <a:xfrm>
              <a:off x="1537777" y="4604060"/>
              <a:ext cx="3094235" cy="1896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6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Number at risk (number censored)</a:t>
              </a:r>
            </a:p>
          </p:txBody>
        </p: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CD322240-F646-99F6-73E3-884E08772C29}"/>
              </a:ext>
            </a:extLst>
          </p:cNvPr>
          <p:cNvSpPr txBox="1"/>
          <p:nvPr/>
        </p:nvSpPr>
        <p:spPr>
          <a:xfrm>
            <a:off x="539552" y="528650"/>
            <a:ext cx="57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1A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14400" y="914400"/>
            <a:ext cx="7315200" cy="3657600"/>
            <a:chOff x="914400" y="914400"/>
            <a:chExt cx="7315200" cy="3657600"/>
          </a:xfrm>
        </p:grpSpPr>
        <p:sp>
          <p:nvSpPr>
            <p:cNvPr id="3" name="rc3"/>
            <p:cNvSpPr/>
            <p:nvPr/>
          </p:nvSpPr>
          <p:spPr>
            <a:xfrm>
              <a:off x="914400" y="914400"/>
              <a:ext cx="7315200" cy="36576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" name="rc4"/>
            <p:cNvSpPr/>
            <p:nvPr/>
          </p:nvSpPr>
          <p:spPr>
            <a:xfrm>
              <a:off x="914400" y="914400"/>
              <a:ext cx="7315200" cy="36575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5"/>
            <p:cNvSpPr/>
            <p:nvPr/>
          </p:nvSpPr>
          <p:spPr>
            <a:xfrm>
              <a:off x="1560072" y="1513432"/>
              <a:ext cx="6593612" cy="256648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" name="pl6"/>
            <p:cNvSpPr/>
            <p:nvPr/>
          </p:nvSpPr>
          <p:spPr>
            <a:xfrm>
              <a:off x="1859781" y="1630091"/>
              <a:ext cx="6168203" cy="1451348"/>
            </a:xfrm>
            <a:custGeom>
              <a:avLst/>
              <a:gdLst/>
              <a:ahLst/>
              <a:cxnLst/>
              <a:rect l="0" t="0" r="0" b="0"/>
              <a:pathLst>
                <a:path w="6168203" h="1451348">
                  <a:moveTo>
                    <a:pt x="0" y="0"/>
                  </a:moveTo>
                  <a:lnTo>
                    <a:pt x="788268" y="0"/>
                  </a:lnTo>
                  <a:lnTo>
                    <a:pt x="788268" y="68622"/>
                  </a:lnTo>
                  <a:lnTo>
                    <a:pt x="842462" y="68622"/>
                  </a:lnTo>
                  <a:lnTo>
                    <a:pt x="842462" y="137245"/>
                  </a:lnTo>
                  <a:lnTo>
                    <a:pt x="1034602" y="137245"/>
                  </a:lnTo>
                  <a:lnTo>
                    <a:pt x="1034602" y="205867"/>
                  </a:lnTo>
                  <a:lnTo>
                    <a:pt x="1113429" y="205867"/>
                  </a:lnTo>
                  <a:lnTo>
                    <a:pt x="1113429" y="274490"/>
                  </a:lnTo>
                  <a:lnTo>
                    <a:pt x="1413957" y="274490"/>
                  </a:lnTo>
                  <a:lnTo>
                    <a:pt x="1413957" y="343113"/>
                  </a:lnTo>
                  <a:lnTo>
                    <a:pt x="1551904" y="343113"/>
                  </a:lnTo>
                  <a:lnTo>
                    <a:pt x="1551904" y="343113"/>
                  </a:lnTo>
                  <a:lnTo>
                    <a:pt x="1832724" y="343113"/>
                  </a:lnTo>
                  <a:lnTo>
                    <a:pt x="1832724" y="414186"/>
                  </a:lnTo>
                  <a:lnTo>
                    <a:pt x="1936185" y="414186"/>
                  </a:lnTo>
                  <a:lnTo>
                    <a:pt x="1936185" y="414186"/>
                  </a:lnTo>
                  <a:lnTo>
                    <a:pt x="2261346" y="414186"/>
                  </a:lnTo>
                  <a:lnTo>
                    <a:pt x="2261346" y="414186"/>
                  </a:lnTo>
                  <a:lnTo>
                    <a:pt x="2266272" y="414186"/>
                  </a:lnTo>
                  <a:lnTo>
                    <a:pt x="2266272" y="414186"/>
                  </a:lnTo>
                  <a:lnTo>
                    <a:pt x="2310612" y="414186"/>
                  </a:lnTo>
                  <a:lnTo>
                    <a:pt x="2310612" y="414186"/>
                  </a:lnTo>
                  <a:lnTo>
                    <a:pt x="2512606" y="414186"/>
                  </a:lnTo>
                  <a:lnTo>
                    <a:pt x="2512606" y="497620"/>
                  </a:lnTo>
                  <a:lnTo>
                    <a:pt x="2517533" y="497620"/>
                  </a:lnTo>
                  <a:lnTo>
                    <a:pt x="2517533" y="581054"/>
                  </a:lnTo>
                  <a:lnTo>
                    <a:pt x="2704747" y="581054"/>
                  </a:lnTo>
                  <a:lnTo>
                    <a:pt x="2704747" y="581054"/>
                  </a:lnTo>
                  <a:lnTo>
                    <a:pt x="2936301" y="581054"/>
                  </a:lnTo>
                  <a:lnTo>
                    <a:pt x="2936301" y="581054"/>
                  </a:lnTo>
                  <a:lnTo>
                    <a:pt x="3394482" y="581054"/>
                  </a:lnTo>
                  <a:lnTo>
                    <a:pt x="3394482" y="673271"/>
                  </a:lnTo>
                  <a:lnTo>
                    <a:pt x="3542282" y="673271"/>
                  </a:lnTo>
                  <a:lnTo>
                    <a:pt x="3542282" y="765487"/>
                  </a:lnTo>
                  <a:lnTo>
                    <a:pt x="3621109" y="765487"/>
                  </a:lnTo>
                  <a:lnTo>
                    <a:pt x="3621109" y="765487"/>
                  </a:lnTo>
                  <a:lnTo>
                    <a:pt x="3630963" y="765487"/>
                  </a:lnTo>
                  <a:lnTo>
                    <a:pt x="3630963" y="863467"/>
                  </a:lnTo>
                  <a:lnTo>
                    <a:pt x="3724570" y="863467"/>
                  </a:lnTo>
                  <a:lnTo>
                    <a:pt x="3724570" y="863467"/>
                  </a:lnTo>
                  <a:lnTo>
                    <a:pt x="3763983" y="863467"/>
                  </a:lnTo>
                  <a:lnTo>
                    <a:pt x="3763983" y="863467"/>
                  </a:lnTo>
                  <a:lnTo>
                    <a:pt x="3793543" y="863467"/>
                  </a:lnTo>
                  <a:lnTo>
                    <a:pt x="3793543" y="863467"/>
                  </a:lnTo>
                  <a:lnTo>
                    <a:pt x="3808323" y="863467"/>
                  </a:lnTo>
                  <a:lnTo>
                    <a:pt x="3808323" y="863467"/>
                  </a:lnTo>
                  <a:lnTo>
                    <a:pt x="3892077" y="863467"/>
                  </a:lnTo>
                  <a:lnTo>
                    <a:pt x="3892077" y="863467"/>
                  </a:lnTo>
                  <a:lnTo>
                    <a:pt x="3956124" y="863467"/>
                  </a:lnTo>
                  <a:lnTo>
                    <a:pt x="3956124" y="1010437"/>
                  </a:lnTo>
                  <a:lnTo>
                    <a:pt x="4030024" y="1010437"/>
                  </a:lnTo>
                  <a:lnTo>
                    <a:pt x="4030024" y="1010437"/>
                  </a:lnTo>
                  <a:lnTo>
                    <a:pt x="4172897" y="1010437"/>
                  </a:lnTo>
                  <a:lnTo>
                    <a:pt x="4172897" y="1010437"/>
                  </a:lnTo>
                  <a:lnTo>
                    <a:pt x="4611372" y="1010437"/>
                  </a:lnTo>
                  <a:lnTo>
                    <a:pt x="4611372" y="1010437"/>
                  </a:lnTo>
                  <a:lnTo>
                    <a:pt x="4749319" y="1010437"/>
                  </a:lnTo>
                  <a:lnTo>
                    <a:pt x="4749319" y="1010437"/>
                  </a:lnTo>
                  <a:lnTo>
                    <a:pt x="4764099" y="1010437"/>
                  </a:lnTo>
                  <a:lnTo>
                    <a:pt x="4764099" y="1010437"/>
                  </a:lnTo>
                  <a:lnTo>
                    <a:pt x="5039993" y="1010437"/>
                  </a:lnTo>
                  <a:lnTo>
                    <a:pt x="5039993" y="1010437"/>
                  </a:lnTo>
                  <a:lnTo>
                    <a:pt x="5089260" y="1010437"/>
                  </a:lnTo>
                  <a:lnTo>
                    <a:pt x="5089260" y="1451348"/>
                  </a:lnTo>
                  <a:lnTo>
                    <a:pt x="5389787" y="1451348"/>
                  </a:lnTo>
                  <a:lnTo>
                    <a:pt x="5389787" y="1451348"/>
                  </a:lnTo>
                  <a:lnTo>
                    <a:pt x="6168203" y="1451348"/>
                  </a:lnTo>
                  <a:lnTo>
                    <a:pt x="6168203" y="1451348"/>
                  </a:lnTo>
                </a:path>
              </a:pathLst>
            </a:custGeom>
            <a:ln w="27101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" name="pg7"/>
            <p:cNvSpPr/>
            <p:nvPr/>
          </p:nvSpPr>
          <p:spPr>
            <a:xfrm>
              <a:off x="1859781" y="1630091"/>
              <a:ext cx="6168203" cy="1965058"/>
            </a:xfrm>
            <a:custGeom>
              <a:avLst/>
              <a:gdLst/>
              <a:ahLst/>
              <a:cxnLst/>
              <a:rect l="0" t="0" r="0" b="0"/>
              <a:pathLst>
                <a:path w="6168203" h="1965058">
                  <a:moveTo>
                    <a:pt x="0" y="0"/>
                  </a:moveTo>
                  <a:lnTo>
                    <a:pt x="788268" y="0"/>
                  </a:lnTo>
                  <a:lnTo>
                    <a:pt x="842462" y="0"/>
                  </a:lnTo>
                  <a:lnTo>
                    <a:pt x="1034602" y="0"/>
                  </a:lnTo>
                  <a:lnTo>
                    <a:pt x="1113429" y="0"/>
                  </a:lnTo>
                  <a:lnTo>
                    <a:pt x="1113429" y="5652"/>
                  </a:lnTo>
                  <a:lnTo>
                    <a:pt x="1413957" y="5652"/>
                  </a:lnTo>
                  <a:lnTo>
                    <a:pt x="1413957" y="45042"/>
                  </a:lnTo>
                  <a:lnTo>
                    <a:pt x="1551904" y="45042"/>
                  </a:lnTo>
                  <a:lnTo>
                    <a:pt x="1832724" y="45042"/>
                  </a:lnTo>
                  <a:lnTo>
                    <a:pt x="1832724" y="88595"/>
                  </a:lnTo>
                  <a:lnTo>
                    <a:pt x="1936185" y="88595"/>
                  </a:lnTo>
                  <a:lnTo>
                    <a:pt x="2261346" y="88595"/>
                  </a:lnTo>
                  <a:lnTo>
                    <a:pt x="2266272" y="88595"/>
                  </a:lnTo>
                  <a:lnTo>
                    <a:pt x="2310612" y="88595"/>
                  </a:lnTo>
                  <a:lnTo>
                    <a:pt x="2512606" y="88595"/>
                  </a:lnTo>
                  <a:lnTo>
                    <a:pt x="2512606" y="137127"/>
                  </a:lnTo>
                  <a:lnTo>
                    <a:pt x="2517533" y="137127"/>
                  </a:lnTo>
                  <a:lnTo>
                    <a:pt x="2517533" y="190633"/>
                  </a:lnTo>
                  <a:lnTo>
                    <a:pt x="2704747" y="190633"/>
                  </a:lnTo>
                  <a:lnTo>
                    <a:pt x="2936301" y="190633"/>
                  </a:lnTo>
                  <a:lnTo>
                    <a:pt x="3394482" y="190633"/>
                  </a:lnTo>
                  <a:lnTo>
                    <a:pt x="3394482" y="249494"/>
                  </a:lnTo>
                  <a:lnTo>
                    <a:pt x="3542282" y="249494"/>
                  </a:lnTo>
                  <a:lnTo>
                    <a:pt x="3542282" y="313201"/>
                  </a:lnTo>
                  <a:lnTo>
                    <a:pt x="3621109" y="313201"/>
                  </a:lnTo>
                  <a:lnTo>
                    <a:pt x="3630963" y="313201"/>
                  </a:lnTo>
                  <a:lnTo>
                    <a:pt x="3630963" y="382131"/>
                  </a:lnTo>
                  <a:lnTo>
                    <a:pt x="3724570" y="382131"/>
                  </a:lnTo>
                  <a:lnTo>
                    <a:pt x="3763983" y="382131"/>
                  </a:lnTo>
                  <a:lnTo>
                    <a:pt x="3793543" y="382131"/>
                  </a:lnTo>
                  <a:lnTo>
                    <a:pt x="3808323" y="382131"/>
                  </a:lnTo>
                  <a:lnTo>
                    <a:pt x="3892077" y="382131"/>
                  </a:lnTo>
                  <a:lnTo>
                    <a:pt x="3956124" y="382131"/>
                  </a:lnTo>
                  <a:lnTo>
                    <a:pt x="3956124" y="454936"/>
                  </a:lnTo>
                  <a:lnTo>
                    <a:pt x="4030024" y="454936"/>
                  </a:lnTo>
                  <a:lnTo>
                    <a:pt x="4172897" y="454936"/>
                  </a:lnTo>
                  <a:lnTo>
                    <a:pt x="4611372" y="454936"/>
                  </a:lnTo>
                  <a:lnTo>
                    <a:pt x="4749319" y="454936"/>
                  </a:lnTo>
                  <a:lnTo>
                    <a:pt x="4764099" y="454936"/>
                  </a:lnTo>
                  <a:lnTo>
                    <a:pt x="5039993" y="454936"/>
                  </a:lnTo>
                  <a:lnTo>
                    <a:pt x="5089260" y="454936"/>
                  </a:lnTo>
                  <a:lnTo>
                    <a:pt x="5089260" y="220739"/>
                  </a:lnTo>
                  <a:lnTo>
                    <a:pt x="5389787" y="220739"/>
                  </a:lnTo>
                  <a:lnTo>
                    <a:pt x="6168203" y="220739"/>
                  </a:lnTo>
                  <a:lnTo>
                    <a:pt x="6168203" y="1965058"/>
                  </a:lnTo>
                  <a:lnTo>
                    <a:pt x="5389787" y="1965058"/>
                  </a:lnTo>
                  <a:lnTo>
                    <a:pt x="5089260" y="1965058"/>
                  </a:lnTo>
                  <a:lnTo>
                    <a:pt x="5089260" y="1401645"/>
                  </a:lnTo>
                  <a:lnTo>
                    <a:pt x="5039993" y="1401645"/>
                  </a:lnTo>
                  <a:lnTo>
                    <a:pt x="4764099" y="1401645"/>
                  </a:lnTo>
                  <a:lnTo>
                    <a:pt x="4749319" y="1401645"/>
                  </a:lnTo>
                  <a:lnTo>
                    <a:pt x="4611372" y="1401645"/>
                  </a:lnTo>
                  <a:lnTo>
                    <a:pt x="4172897" y="1401645"/>
                  </a:lnTo>
                  <a:lnTo>
                    <a:pt x="4030024" y="1401645"/>
                  </a:lnTo>
                  <a:lnTo>
                    <a:pt x="3956124" y="1401645"/>
                  </a:lnTo>
                  <a:lnTo>
                    <a:pt x="3956124" y="1226054"/>
                  </a:lnTo>
                  <a:lnTo>
                    <a:pt x="3892077" y="1226054"/>
                  </a:lnTo>
                  <a:lnTo>
                    <a:pt x="3808323" y="1226054"/>
                  </a:lnTo>
                  <a:lnTo>
                    <a:pt x="3793543" y="1226054"/>
                  </a:lnTo>
                  <a:lnTo>
                    <a:pt x="3763983" y="1226054"/>
                  </a:lnTo>
                  <a:lnTo>
                    <a:pt x="3724570" y="1226054"/>
                  </a:lnTo>
                  <a:lnTo>
                    <a:pt x="3630963" y="1226054"/>
                  </a:lnTo>
                  <a:lnTo>
                    <a:pt x="3630963" y="1116503"/>
                  </a:lnTo>
                  <a:lnTo>
                    <a:pt x="3621109" y="1116503"/>
                  </a:lnTo>
                  <a:lnTo>
                    <a:pt x="3542282" y="1116503"/>
                  </a:lnTo>
                  <a:lnTo>
                    <a:pt x="3542282" y="1010860"/>
                  </a:lnTo>
                  <a:lnTo>
                    <a:pt x="3394482" y="1010860"/>
                  </a:lnTo>
                  <a:lnTo>
                    <a:pt x="3394482" y="900331"/>
                  </a:lnTo>
                  <a:lnTo>
                    <a:pt x="2936301" y="900331"/>
                  </a:lnTo>
                  <a:lnTo>
                    <a:pt x="2704747" y="900331"/>
                  </a:lnTo>
                  <a:lnTo>
                    <a:pt x="2517533" y="900331"/>
                  </a:lnTo>
                  <a:lnTo>
                    <a:pt x="2517533" y="798936"/>
                  </a:lnTo>
                  <a:lnTo>
                    <a:pt x="2512606" y="798936"/>
                  </a:lnTo>
                  <a:lnTo>
                    <a:pt x="2512606" y="692548"/>
                  </a:lnTo>
                  <a:lnTo>
                    <a:pt x="2310612" y="692548"/>
                  </a:lnTo>
                  <a:lnTo>
                    <a:pt x="2266272" y="692548"/>
                  </a:lnTo>
                  <a:lnTo>
                    <a:pt x="2261346" y="692548"/>
                  </a:lnTo>
                  <a:lnTo>
                    <a:pt x="1936185" y="692548"/>
                  </a:lnTo>
                  <a:lnTo>
                    <a:pt x="1832724" y="692548"/>
                  </a:lnTo>
                  <a:lnTo>
                    <a:pt x="1832724" y="602354"/>
                  </a:lnTo>
                  <a:lnTo>
                    <a:pt x="1551904" y="602354"/>
                  </a:lnTo>
                  <a:lnTo>
                    <a:pt x="1413957" y="602354"/>
                  </a:lnTo>
                  <a:lnTo>
                    <a:pt x="1413957" y="512276"/>
                  </a:lnTo>
                  <a:lnTo>
                    <a:pt x="1113429" y="512276"/>
                  </a:lnTo>
                  <a:lnTo>
                    <a:pt x="1113429" y="417075"/>
                  </a:lnTo>
                  <a:lnTo>
                    <a:pt x="1034602" y="417075"/>
                  </a:lnTo>
                  <a:lnTo>
                    <a:pt x="1034602" y="314234"/>
                  </a:lnTo>
                  <a:lnTo>
                    <a:pt x="842462" y="314234"/>
                  </a:lnTo>
                  <a:lnTo>
                    <a:pt x="842462" y="197325"/>
                  </a:lnTo>
                  <a:lnTo>
                    <a:pt x="788268" y="197325"/>
                  </a:lnTo>
                  <a:lnTo>
                    <a:pt x="788268" y="0"/>
                  </a:lnTo>
                  <a:close/>
                </a:path>
              </a:pathLst>
            </a:custGeom>
            <a:solidFill>
              <a:srgbClr val="BEBEBE">
                <a:alpha val="29803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8" name="pl8"/>
            <p:cNvSpPr/>
            <p:nvPr/>
          </p:nvSpPr>
          <p:spPr>
            <a:xfrm>
              <a:off x="1859781" y="1630091"/>
              <a:ext cx="6168203" cy="454936"/>
            </a:xfrm>
            <a:custGeom>
              <a:avLst/>
              <a:gdLst/>
              <a:ahLst/>
              <a:cxnLst/>
              <a:rect l="0" t="0" r="0" b="0"/>
              <a:pathLst>
                <a:path w="6168203" h="454936">
                  <a:moveTo>
                    <a:pt x="0" y="0"/>
                  </a:moveTo>
                  <a:lnTo>
                    <a:pt x="788268" y="0"/>
                  </a:lnTo>
                  <a:lnTo>
                    <a:pt x="788268" y="0"/>
                  </a:lnTo>
                  <a:lnTo>
                    <a:pt x="842462" y="0"/>
                  </a:lnTo>
                  <a:lnTo>
                    <a:pt x="842462" y="0"/>
                  </a:lnTo>
                  <a:lnTo>
                    <a:pt x="1034602" y="0"/>
                  </a:lnTo>
                  <a:lnTo>
                    <a:pt x="1034602" y="0"/>
                  </a:lnTo>
                  <a:lnTo>
                    <a:pt x="1113429" y="0"/>
                  </a:lnTo>
                  <a:lnTo>
                    <a:pt x="1113429" y="5652"/>
                  </a:lnTo>
                  <a:lnTo>
                    <a:pt x="1413957" y="5652"/>
                  </a:lnTo>
                  <a:lnTo>
                    <a:pt x="1413957" y="45042"/>
                  </a:lnTo>
                  <a:lnTo>
                    <a:pt x="1551904" y="45042"/>
                  </a:lnTo>
                  <a:lnTo>
                    <a:pt x="1551904" y="45042"/>
                  </a:lnTo>
                  <a:lnTo>
                    <a:pt x="1832724" y="45042"/>
                  </a:lnTo>
                  <a:lnTo>
                    <a:pt x="1832724" y="88595"/>
                  </a:lnTo>
                  <a:lnTo>
                    <a:pt x="1936185" y="88595"/>
                  </a:lnTo>
                  <a:lnTo>
                    <a:pt x="1936185" y="88595"/>
                  </a:lnTo>
                  <a:lnTo>
                    <a:pt x="2261346" y="88595"/>
                  </a:lnTo>
                  <a:lnTo>
                    <a:pt x="2261346" y="88595"/>
                  </a:lnTo>
                  <a:lnTo>
                    <a:pt x="2266272" y="88595"/>
                  </a:lnTo>
                  <a:lnTo>
                    <a:pt x="2266272" y="88595"/>
                  </a:lnTo>
                  <a:lnTo>
                    <a:pt x="2310612" y="88595"/>
                  </a:lnTo>
                  <a:lnTo>
                    <a:pt x="2310612" y="88595"/>
                  </a:lnTo>
                  <a:lnTo>
                    <a:pt x="2512606" y="88595"/>
                  </a:lnTo>
                  <a:lnTo>
                    <a:pt x="2512606" y="137127"/>
                  </a:lnTo>
                  <a:lnTo>
                    <a:pt x="2517533" y="137127"/>
                  </a:lnTo>
                  <a:lnTo>
                    <a:pt x="2517533" y="190633"/>
                  </a:lnTo>
                  <a:lnTo>
                    <a:pt x="2704747" y="190633"/>
                  </a:lnTo>
                  <a:lnTo>
                    <a:pt x="2704747" y="190633"/>
                  </a:lnTo>
                  <a:lnTo>
                    <a:pt x="2936301" y="190633"/>
                  </a:lnTo>
                  <a:lnTo>
                    <a:pt x="2936301" y="190633"/>
                  </a:lnTo>
                  <a:lnTo>
                    <a:pt x="3394482" y="190633"/>
                  </a:lnTo>
                  <a:lnTo>
                    <a:pt x="3394482" y="249494"/>
                  </a:lnTo>
                  <a:lnTo>
                    <a:pt x="3542282" y="249494"/>
                  </a:lnTo>
                  <a:lnTo>
                    <a:pt x="3542282" y="313201"/>
                  </a:lnTo>
                  <a:lnTo>
                    <a:pt x="3621109" y="313201"/>
                  </a:lnTo>
                  <a:lnTo>
                    <a:pt x="3621109" y="313201"/>
                  </a:lnTo>
                  <a:lnTo>
                    <a:pt x="3630963" y="313201"/>
                  </a:lnTo>
                  <a:lnTo>
                    <a:pt x="3630963" y="382131"/>
                  </a:lnTo>
                  <a:lnTo>
                    <a:pt x="3724570" y="382131"/>
                  </a:lnTo>
                  <a:lnTo>
                    <a:pt x="3724570" y="382131"/>
                  </a:lnTo>
                  <a:lnTo>
                    <a:pt x="3763983" y="382131"/>
                  </a:lnTo>
                  <a:lnTo>
                    <a:pt x="3763983" y="382131"/>
                  </a:lnTo>
                  <a:lnTo>
                    <a:pt x="3793543" y="382131"/>
                  </a:lnTo>
                  <a:lnTo>
                    <a:pt x="3793543" y="382131"/>
                  </a:lnTo>
                  <a:lnTo>
                    <a:pt x="3808323" y="382131"/>
                  </a:lnTo>
                  <a:lnTo>
                    <a:pt x="3808323" y="382131"/>
                  </a:lnTo>
                  <a:lnTo>
                    <a:pt x="3892077" y="382131"/>
                  </a:lnTo>
                  <a:lnTo>
                    <a:pt x="3892077" y="382131"/>
                  </a:lnTo>
                  <a:lnTo>
                    <a:pt x="3956124" y="382131"/>
                  </a:lnTo>
                  <a:lnTo>
                    <a:pt x="3956124" y="454936"/>
                  </a:lnTo>
                  <a:lnTo>
                    <a:pt x="4030024" y="454936"/>
                  </a:lnTo>
                  <a:lnTo>
                    <a:pt x="4030024" y="454936"/>
                  </a:lnTo>
                  <a:lnTo>
                    <a:pt x="4172897" y="454936"/>
                  </a:lnTo>
                  <a:lnTo>
                    <a:pt x="4172897" y="454936"/>
                  </a:lnTo>
                  <a:lnTo>
                    <a:pt x="4611372" y="454936"/>
                  </a:lnTo>
                  <a:lnTo>
                    <a:pt x="4611372" y="454936"/>
                  </a:lnTo>
                  <a:lnTo>
                    <a:pt x="4749319" y="454936"/>
                  </a:lnTo>
                  <a:lnTo>
                    <a:pt x="4749319" y="454936"/>
                  </a:lnTo>
                  <a:lnTo>
                    <a:pt x="4764099" y="454936"/>
                  </a:lnTo>
                  <a:lnTo>
                    <a:pt x="4764099" y="454936"/>
                  </a:lnTo>
                  <a:lnTo>
                    <a:pt x="5039993" y="454936"/>
                  </a:lnTo>
                  <a:lnTo>
                    <a:pt x="5039993" y="454936"/>
                  </a:lnTo>
                  <a:lnTo>
                    <a:pt x="5089260" y="454936"/>
                  </a:lnTo>
                  <a:lnTo>
                    <a:pt x="5089260" y="220739"/>
                  </a:lnTo>
                  <a:lnTo>
                    <a:pt x="5389787" y="220739"/>
                  </a:lnTo>
                  <a:lnTo>
                    <a:pt x="5389787" y="220739"/>
                  </a:lnTo>
                  <a:lnTo>
                    <a:pt x="6168203" y="220739"/>
                  </a:lnTo>
                  <a:lnTo>
                    <a:pt x="6168203" y="220739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9" name="pl9"/>
            <p:cNvSpPr/>
            <p:nvPr/>
          </p:nvSpPr>
          <p:spPr>
            <a:xfrm>
              <a:off x="1859781" y="1630091"/>
              <a:ext cx="6168203" cy="1965058"/>
            </a:xfrm>
            <a:custGeom>
              <a:avLst/>
              <a:gdLst/>
              <a:ahLst/>
              <a:cxnLst/>
              <a:rect l="0" t="0" r="0" b="0"/>
              <a:pathLst>
                <a:path w="6168203" h="1965058">
                  <a:moveTo>
                    <a:pt x="6168203" y="1965058"/>
                  </a:moveTo>
                  <a:lnTo>
                    <a:pt x="6168203" y="1965058"/>
                  </a:lnTo>
                  <a:lnTo>
                    <a:pt x="5389787" y="1965058"/>
                  </a:lnTo>
                  <a:lnTo>
                    <a:pt x="5389787" y="1965058"/>
                  </a:lnTo>
                  <a:lnTo>
                    <a:pt x="5089260" y="1965058"/>
                  </a:lnTo>
                  <a:lnTo>
                    <a:pt x="5089260" y="1401645"/>
                  </a:lnTo>
                  <a:lnTo>
                    <a:pt x="5039993" y="1401645"/>
                  </a:lnTo>
                  <a:lnTo>
                    <a:pt x="5039993" y="1401645"/>
                  </a:lnTo>
                  <a:lnTo>
                    <a:pt x="4764099" y="1401645"/>
                  </a:lnTo>
                  <a:lnTo>
                    <a:pt x="4764099" y="1401645"/>
                  </a:lnTo>
                  <a:lnTo>
                    <a:pt x="4749319" y="1401645"/>
                  </a:lnTo>
                  <a:lnTo>
                    <a:pt x="4749319" y="1401645"/>
                  </a:lnTo>
                  <a:lnTo>
                    <a:pt x="4611372" y="1401645"/>
                  </a:lnTo>
                  <a:lnTo>
                    <a:pt x="4611372" y="1401645"/>
                  </a:lnTo>
                  <a:lnTo>
                    <a:pt x="4172897" y="1401645"/>
                  </a:lnTo>
                  <a:lnTo>
                    <a:pt x="4172897" y="1401645"/>
                  </a:lnTo>
                  <a:lnTo>
                    <a:pt x="4030024" y="1401645"/>
                  </a:lnTo>
                  <a:lnTo>
                    <a:pt x="4030024" y="1401645"/>
                  </a:lnTo>
                  <a:lnTo>
                    <a:pt x="3956124" y="1401645"/>
                  </a:lnTo>
                  <a:lnTo>
                    <a:pt x="3956124" y="1226054"/>
                  </a:lnTo>
                  <a:lnTo>
                    <a:pt x="3892077" y="1226054"/>
                  </a:lnTo>
                  <a:lnTo>
                    <a:pt x="3892077" y="1226054"/>
                  </a:lnTo>
                  <a:lnTo>
                    <a:pt x="3808323" y="1226054"/>
                  </a:lnTo>
                  <a:lnTo>
                    <a:pt x="3808323" y="1226054"/>
                  </a:lnTo>
                  <a:lnTo>
                    <a:pt x="3793543" y="1226054"/>
                  </a:lnTo>
                  <a:lnTo>
                    <a:pt x="3793543" y="1226054"/>
                  </a:lnTo>
                  <a:lnTo>
                    <a:pt x="3763983" y="1226054"/>
                  </a:lnTo>
                  <a:lnTo>
                    <a:pt x="3763983" y="1226054"/>
                  </a:lnTo>
                  <a:lnTo>
                    <a:pt x="3724570" y="1226054"/>
                  </a:lnTo>
                  <a:lnTo>
                    <a:pt x="3724570" y="1226054"/>
                  </a:lnTo>
                  <a:lnTo>
                    <a:pt x="3630963" y="1226054"/>
                  </a:lnTo>
                  <a:lnTo>
                    <a:pt x="3630963" y="1116503"/>
                  </a:lnTo>
                  <a:lnTo>
                    <a:pt x="3621109" y="1116503"/>
                  </a:lnTo>
                  <a:lnTo>
                    <a:pt x="3621109" y="1116503"/>
                  </a:lnTo>
                  <a:lnTo>
                    <a:pt x="3542282" y="1116503"/>
                  </a:lnTo>
                  <a:lnTo>
                    <a:pt x="3542282" y="1010860"/>
                  </a:lnTo>
                  <a:lnTo>
                    <a:pt x="3394482" y="1010860"/>
                  </a:lnTo>
                  <a:lnTo>
                    <a:pt x="3394482" y="900331"/>
                  </a:lnTo>
                  <a:lnTo>
                    <a:pt x="2936301" y="900331"/>
                  </a:lnTo>
                  <a:lnTo>
                    <a:pt x="2936301" y="900331"/>
                  </a:lnTo>
                  <a:lnTo>
                    <a:pt x="2704747" y="900331"/>
                  </a:lnTo>
                  <a:lnTo>
                    <a:pt x="2704747" y="900331"/>
                  </a:lnTo>
                  <a:lnTo>
                    <a:pt x="2517533" y="900331"/>
                  </a:lnTo>
                  <a:lnTo>
                    <a:pt x="2517533" y="798936"/>
                  </a:lnTo>
                  <a:lnTo>
                    <a:pt x="2512606" y="798936"/>
                  </a:lnTo>
                  <a:lnTo>
                    <a:pt x="2512606" y="692548"/>
                  </a:lnTo>
                  <a:lnTo>
                    <a:pt x="2310612" y="692548"/>
                  </a:lnTo>
                  <a:lnTo>
                    <a:pt x="2310612" y="692548"/>
                  </a:lnTo>
                  <a:lnTo>
                    <a:pt x="2266272" y="692548"/>
                  </a:lnTo>
                  <a:lnTo>
                    <a:pt x="2266272" y="692548"/>
                  </a:lnTo>
                  <a:lnTo>
                    <a:pt x="2261346" y="692548"/>
                  </a:lnTo>
                  <a:lnTo>
                    <a:pt x="2261346" y="692548"/>
                  </a:lnTo>
                  <a:lnTo>
                    <a:pt x="1936185" y="692548"/>
                  </a:lnTo>
                  <a:lnTo>
                    <a:pt x="1936185" y="692548"/>
                  </a:lnTo>
                  <a:lnTo>
                    <a:pt x="1832724" y="692548"/>
                  </a:lnTo>
                  <a:lnTo>
                    <a:pt x="1832724" y="602354"/>
                  </a:lnTo>
                  <a:lnTo>
                    <a:pt x="1551904" y="602354"/>
                  </a:lnTo>
                  <a:lnTo>
                    <a:pt x="1551904" y="602354"/>
                  </a:lnTo>
                  <a:lnTo>
                    <a:pt x="1413957" y="602354"/>
                  </a:lnTo>
                  <a:lnTo>
                    <a:pt x="1413957" y="512276"/>
                  </a:lnTo>
                  <a:lnTo>
                    <a:pt x="1113429" y="512276"/>
                  </a:lnTo>
                  <a:lnTo>
                    <a:pt x="1113429" y="417075"/>
                  </a:lnTo>
                  <a:lnTo>
                    <a:pt x="1034602" y="417075"/>
                  </a:lnTo>
                  <a:lnTo>
                    <a:pt x="1034602" y="314234"/>
                  </a:lnTo>
                  <a:lnTo>
                    <a:pt x="842462" y="314234"/>
                  </a:lnTo>
                  <a:lnTo>
                    <a:pt x="842462" y="197325"/>
                  </a:lnTo>
                  <a:lnTo>
                    <a:pt x="788268" y="197325"/>
                  </a:lnTo>
                  <a:lnTo>
                    <a:pt x="788268" y="0"/>
                  </a:lnTo>
                  <a:lnTo>
                    <a:pt x="0" y="0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10" name="tx10"/>
            <p:cNvSpPr/>
            <p:nvPr/>
          </p:nvSpPr>
          <p:spPr>
            <a:xfrm>
              <a:off x="3360702" y="1928657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1" name="tx11"/>
            <p:cNvSpPr/>
            <p:nvPr/>
          </p:nvSpPr>
          <p:spPr>
            <a:xfrm>
              <a:off x="3744983" y="1999730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2" name="tx12"/>
            <p:cNvSpPr/>
            <p:nvPr/>
          </p:nvSpPr>
          <p:spPr>
            <a:xfrm>
              <a:off x="4070144" y="1999730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3" name="tx13"/>
            <p:cNvSpPr/>
            <p:nvPr/>
          </p:nvSpPr>
          <p:spPr>
            <a:xfrm>
              <a:off x="4075070" y="1999730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4" name="tx14"/>
            <p:cNvSpPr/>
            <p:nvPr/>
          </p:nvSpPr>
          <p:spPr>
            <a:xfrm>
              <a:off x="4119410" y="1999730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5" name="tx15"/>
            <p:cNvSpPr/>
            <p:nvPr/>
          </p:nvSpPr>
          <p:spPr>
            <a:xfrm>
              <a:off x="4513545" y="2166598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6" name="tx16"/>
            <p:cNvSpPr/>
            <p:nvPr/>
          </p:nvSpPr>
          <p:spPr>
            <a:xfrm>
              <a:off x="4745099" y="2166598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7" name="tx17"/>
            <p:cNvSpPr/>
            <p:nvPr/>
          </p:nvSpPr>
          <p:spPr>
            <a:xfrm>
              <a:off x="5429907" y="235103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8" name="tx18"/>
            <p:cNvSpPr/>
            <p:nvPr/>
          </p:nvSpPr>
          <p:spPr>
            <a:xfrm>
              <a:off x="5533368" y="244901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9" name="tx19"/>
            <p:cNvSpPr/>
            <p:nvPr/>
          </p:nvSpPr>
          <p:spPr>
            <a:xfrm>
              <a:off x="5572781" y="244901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20" name="tx20"/>
            <p:cNvSpPr/>
            <p:nvPr/>
          </p:nvSpPr>
          <p:spPr>
            <a:xfrm>
              <a:off x="5602341" y="244901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21" name="tx21"/>
            <p:cNvSpPr/>
            <p:nvPr/>
          </p:nvSpPr>
          <p:spPr>
            <a:xfrm>
              <a:off x="5617121" y="244901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22" name="tx22"/>
            <p:cNvSpPr/>
            <p:nvPr/>
          </p:nvSpPr>
          <p:spPr>
            <a:xfrm>
              <a:off x="5700875" y="244901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23" name="tx23"/>
            <p:cNvSpPr/>
            <p:nvPr/>
          </p:nvSpPr>
          <p:spPr>
            <a:xfrm>
              <a:off x="5838822" y="259598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24" name="tx24"/>
            <p:cNvSpPr/>
            <p:nvPr/>
          </p:nvSpPr>
          <p:spPr>
            <a:xfrm>
              <a:off x="5981695" y="259598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25" name="tx25"/>
            <p:cNvSpPr/>
            <p:nvPr/>
          </p:nvSpPr>
          <p:spPr>
            <a:xfrm>
              <a:off x="6420170" y="259598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26" name="tx26"/>
            <p:cNvSpPr/>
            <p:nvPr/>
          </p:nvSpPr>
          <p:spPr>
            <a:xfrm>
              <a:off x="6558117" y="259598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27" name="tx27"/>
            <p:cNvSpPr/>
            <p:nvPr/>
          </p:nvSpPr>
          <p:spPr>
            <a:xfrm>
              <a:off x="6572897" y="259598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28" name="tx28"/>
            <p:cNvSpPr/>
            <p:nvPr/>
          </p:nvSpPr>
          <p:spPr>
            <a:xfrm>
              <a:off x="6848791" y="259598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29" name="tx29"/>
            <p:cNvSpPr/>
            <p:nvPr/>
          </p:nvSpPr>
          <p:spPr>
            <a:xfrm>
              <a:off x="7198585" y="3036892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30" name="tx30"/>
            <p:cNvSpPr/>
            <p:nvPr/>
          </p:nvSpPr>
          <p:spPr>
            <a:xfrm>
              <a:off x="7977001" y="3036892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31" name="pl31"/>
            <p:cNvSpPr/>
            <p:nvPr/>
          </p:nvSpPr>
          <p:spPr>
            <a:xfrm>
              <a:off x="1859781" y="2796675"/>
              <a:ext cx="5089260" cy="0"/>
            </a:xfrm>
            <a:custGeom>
              <a:avLst/>
              <a:gdLst/>
              <a:ahLst/>
              <a:cxnLst/>
              <a:rect l="0" t="0" r="0" b="0"/>
              <a:pathLst>
                <a:path w="5089260">
                  <a:moveTo>
                    <a:pt x="0" y="0"/>
                  </a:moveTo>
                  <a:lnTo>
                    <a:pt x="508926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2"/>
            <p:cNvSpPr/>
            <p:nvPr/>
          </p:nvSpPr>
          <p:spPr>
            <a:xfrm>
              <a:off x="6949042" y="2796675"/>
              <a:ext cx="0" cy="1166584"/>
            </a:xfrm>
            <a:custGeom>
              <a:avLst/>
              <a:gdLst/>
              <a:ahLst/>
              <a:cxnLst/>
              <a:rect l="0" t="0" r="0" b="0"/>
              <a:pathLst>
                <a:path h="1166584">
                  <a:moveTo>
                    <a:pt x="0" y="116658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3"/>
            <p:cNvSpPr/>
            <p:nvPr/>
          </p:nvSpPr>
          <p:spPr>
            <a:xfrm>
              <a:off x="1560072" y="1513432"/>
              <a:ext cx="0" cy="2566485"/>
            </a:xfrm>
            <a:custGeom>
              <a:avLst/>
              <a:gdLst/>
              <a:ahLst/>
              <a:cxnLst/>
              <a:rect l="0" t="0" r="0" b="0"/>
              <a:pathLst>
                <a:path h="2566485">
                  <a:moveTo>
                    <a:pt x="0" y="2566485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tx34"/>
            <p:cNvSpPr/>
            <p:nvPr/>
          </p:nvSpPr>
          <p:spPr>
            <a:xfrm>
              <a:off x="1195134" y="3908453"/>
              <a:ext cx="296614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.00</a:t>
              </a:r>
            </a:p>
          </p:txBody>
        </p:sp>
        <p:sp>
          <p:nvSpPr>
            <p:cNvPr id="35" name="tx35"/>
            <p:cNvSpPr/>
            <p:nvPr/>
          </p:nvSpPr>
          <p:spPr>
            <a:xfrm>
              <a:off x="1195134" y="3324789"/>
              <a:ext cx="296614" cy="10983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.25</a:t>
              </a:r>
            </a:p>
          </p:txBody>
        </p:sp>
        <p:sp>
          <p:nvSpPr>
            <p:cNvPr id="36" name="tx36"/>
            <p:cNvSpPr/>
            <p:nvPr/>
          </p:nvSpPr>
          <p:spPr>
            <a:xfrm>
              <a:off x="1195134" y="2741869"/>
              <a:ext cx="296614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.50</a:t>
              </a:r>
            </a:p>
          </p:txBody>
        </p:sp>
        <p:sp>
          <p:nvSpPr>
            <p:cNvPr id="37" name="tx37"/>
            <p:cNvSpPr/>
            <p:nvPr/>
          </p:nvSpPr>
          <p:spPr>
            <a:xfrm>
              <a:off x="1195134" y="2158577"/>
              <a:ext cx="296614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.75</a:t>
              </a:r>
            </a:p>
          </p:txBody>
        </p:sp>
        <p:sp>
          <p:nvSpPr>
            <p:cNvPr id="38" name="tx38"/>
            <p:cNvSpPr/>
            <p:nvPr/>
          </p:nvSpPr>
          <p:spPr>
            <a:xfrm>
              <a:off x="1195134" y="1575285"/>
              <a:ext cx="296614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1.00</a:t>
              </a:r>
            </a:p>
          </p:txBody>
        </p:sp>
        <p:sp>
          <p:nvSpPr>
            <p:cNvPr id="39" name="pl39"/>
            <p:cNvSpPr/>
            <p:nvPr/>
          </p:nvSpPr>
          <p:spPr>
            <a:xfrm>
              <a:off x="1522114" y="3963259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" name="pl40"/>
            <p:cNvSpPr/>
            <p:nvPr/>
          </p:nvSpPr>
          <p:spPr>
            <a:xfrm>
              <a:off x="1522114" y="3379967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" name="pl41"/>
            <p:cNvSpPr/>
            <p:nvPr/>
          </p:nvSpPr>
          <p:spPr>
            <a:xfrm>
              <a:off x="1522114" y="2796675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" name="pl42"/>
            <p:cNvSpPr/>
            <p:nvPr/>
          </p:nvSpPr>
          <p:spPr>
            <a:xfrm>
              <a:off x="1522114" y="2213383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" name="pl43"/>
            <p:cNvSpPr/>
            <p:nvPr/>
          </p:nvSpPr>
          <p:spPr>
            <a:xfrm>
              <a:off x="1522114" y="1630091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" name="pl44"/>
            <p:cNvSpPr/>
            <p:nvPr/>
          </p:nvSpPr>
          <p:spPr>
            <a:xfrm>
              <a:off x="1560072" y="4079918"/>
              <a:ext cx="6593612" cy="0"/>
            </a:xfrm>
            <a:custGeom>
              <a:avLst/>
              <a:gdLst/>
              <a:ahLst/>
              <a:cxnLst/>
              <a:rect l="0" t="0" r="0" b="0"/>
              <a:pathLst>
                <a:path w="6593612">
                  <a:moveTo>
                    <a:pt x="0" y="0"/>
                  </a:moveTo>
                  <a:lnTo>
                    <a:pt x="6593612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" name="pl45"/>
            <p:cNvSpPr/>
            <p:nvPr/>
          </p:nvSpPr>
          <p:spPr>
            <a:xfrm>
              <a:off x="1859781" y="40799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" name="pl46"/>
            <p:cNvSpPr/>
            <p:nvPr/>
          </p:nvSpPr>
          <p:spPr>
            <a:xfrm>
              <a:off x="3358330" y="40799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" name="pl47"/>
            <p:cNvSpPr/>
            <p:nvPr/>
          </p:nvSpPr>
          <p:spPr>
            <a:xfrm>
              <a:off x="4856878" y="40799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" name="pl48"/>
            <p:cNvSpPr/>
            <p:nvPr/>
          </p:nvSpPr>
          <p:spPr>
            <a:xfrm>
              <a:off x="6355426" y="40799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" name="pl49"/>
            <p:cNvSpPr/>
            <p:nvPr/>
          </p:nvSpPr>
          <p:spPr>
            <a:xfrm>
              <a:off x="7853975" y="40799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" name="tx50"/>
            <p:cNvSpPr/>
            <p:nvPr/>
          </p:nvSpPr>
          <p:spPr>
            <a:xfrm>
              <a:off x="1817403" y="4148093"/>
              <a:ext cx="84757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</a:t>
              </a:r>
            </a:p>
          </p:txBody>
        </p:sp>
        <p:sp>
          <p:nvSpPr>
            <p:cNvPr id="51" name="tx51"/>
            <p:cNvSpPr/>
            <p:nvPr/>
          </p:nvSpPr>
          <p:spPr>
            <a:xfrm>
              <a:off x="3273572" y="4148093"/>
              <a:ext cx="169515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10</a:t>
              </a:r>
            </a:p>
          </p:txBody>
        </p:sp>
        <p:sp>
          <p:nvSpPr>
            <p:cNvPr id="52" name="tx52"/>
            <p:cNvSpPr/>
            <p:nvPr/>
          </p:nvSpPr>
          <p:spPr>
            <a:xfrm>
              <a:off x="4772120" y="4147721"/>
              <a:ext cx="169515" cy="10983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20</a:t>
              </a:r>
            </a:p>
          </p:txBody>
        </p:sp>
        <p:sp>
          <p:nvSpPr>
            <p:cNvPr id="53" name="tx53"/>
            <p:cNvSpPr/>
            <p:nvPr/>
          </p:nvSpPr>
          <p:spPr>
            <a:xfrm>
              <a:off x="6270669" y="4147944"/>
              <a:ext cx="169515" cy="1096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30</a:t>
              </a:r>
            </a:p>
          </p:txBody>
        </p:sp>
        <p:sp>
          <p:nvSpPr>
            <p:cNvPr id="54" name="tx54"/>
            <p:cNvSpPr/>
            <p:nvPr/>
          </p:nvSpPr>
          <p:spPr>
            <a:xfrm>
              <a:off x="7769217" y="4147795"/>
              <a:ext cx="169515" cy="1097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40</a:t>
              </a:r>
            </a:p>
          </p:txBody>
        </p:sp>
        <p:sp>
          <p:nvSpPr>
            <p:cNvPr id="55" name="tx55"/>
            <p:cNvSpPr/>
            <p:nvPr/>
          </p:nvSpPr>
          <p:spPr>
            <a:xfrm>
              <a:off x="4609799" y="4325403"/>
              <a:ext cx="494158" cy="13135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Month</a:t>
              </a:r>
            </a:p>
          </p:txBody>
        </p:sp>
        <p:sp>
          <p:nvSpPr>
            <p:cNvPr id="56" name="tx56"/>
            <p:cNvSpPr/>
            <p:nvPr/>
          </p:nvSpPr>
          <p:spPr>
            <a:xfrm rot="-5400000">
              <a:off x="415720" y="2712116"/>
              <a:ext cx="1235137" cy="16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OS (probability)</a:t>
              </a:r>
            </a:p>
          </p:txBody>
        </p:sp>
        <p:sp>
          <p:nvSpPr>
            <p:cNvPr id="57" name="rc57"/>
            <p:cNvSpPr/>
            <p:nvPr/>
          </p:nvSpPr>
          <p:spPr>
            <a:xfrm>
              <a:off x="4332640" y="990315"/>
              <a:ext cx="1048476" cy="37128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58" name="pl58"/>
            <p:cNvSpPr/>
            <p:nvPr/>
          </p:nvSpPr>
          <p:spPr>
            <a:xfrm>
              <a:off x="4493764" y="1175958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27101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tx59"/>
            <p:cNvSpPr/>
            <p:nvPr/>
          </p:nvSpPr>
          <p:spPr>
            <a:xfrm>
              <a:off x="4530562" y="1131411"/>
              <a:ext cx="101968" cy="8909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374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374">
                  <a:solidFill>
                    <a:srgbClr val="F8766D">
                      <a:alpha val="100000"/>
                    </a:srgbClr>
                  </a:solidFill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60" name="tx60"/>
            <p:cNvSpPr/>
            <p:nvPr/>
          </p:nvSpPr>
          <p:spPr>
            <a:xfrm>
              <a:off x="4754537" y="1125388"/>
              <a:ext cx="550664" cy="96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Censored</a:t>
              </a: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1188720" y="4572000"/>
            <a:ext cx="7040880" cy="1828800"/>
            <a:chOff x="1188720" y="4572000"/>
            <a:chExt cx="7040880" cy="1828800"/>
          </a:xfrm>
        </p:grpSpPr>
        <p:sp>
          <p:nvSpPr>
            <p:cNvPr id="62" name="rc3"/>
            <p:cNvSpPr/>
            <p:nvPr/>
          </p:nvSpPr>
          <p:spPr>
            <a:xfrm>
              <a:off x="1188720" y="4572000"/>
              <a:ext cx="7040880" cy="1828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rc4"/>
            <p:cNvSpPr/>
            <p:nvPr/>
          </p:nvSpPr>
          <p:spPr>
            <a:xfrm>
              <a:off x="1188720" y="4572000"/>
              <a:ext cx="7040880" cy="1828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rc5"/>
            <p:cNvSpPr/>
            <p:nvPr/>
          </p:nvSpPr>
          <p:spPr>
            <a:xfrm>
              <a:off x="1537777" y="4914529"/>
              <a:ext cx="6615906" cy="994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5" name="tx6"/>
            <p:cNvSpPr/>
            <p:nvPr/>
          </p:nvSpPr>
          <p:spPr>
            <a:xfrm>
              <a:off x="1626110" y="5318211"/>
              <a:ext cx="424780" cy="15172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8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34 (0)</a:t>
              </a:r>
            </a:p>
          </p:txBody>
        </p:sp>
        <p:sp>
          <p:nvSpPr>
            <p:cNvPr id="66" name="tx7"/>
            <p:cNvSpPr/>
            <p:nvPr/>
          </p:nvSpPr>
          <p:spPr>
            <a:xfrm>
              <a:off x="3129725" y="5318211"/>
              <a:ext cx="424780" cy="15172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8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29 (0)</a:t>
              </a:r>
            </a:p>
          </p:txBody>
        </p:sp>
        <p:sp>
          <p:nvSpPr>
            <p:cNvPr id="67" name="tx8"/>
            <p:cNvSpPr/>
            <p:nvPr/>
          </p:nvSpPr>
          <p:spPr>
            <a:xfrm>
              <a:off x="4633341" y="5318211"/>
              <a:ext cx="424780" cy="15172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8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19 (7)</a:t>
              </a:r>
            </a:p>
          </p:txBody>
        </p:sp>
        <p:sp>
          <p:nvSpPr>
            <p:cNvPr id="68" name="tx9"/>
            <p:cNvSpPr/>
            <p:nvPr/>
          </p:nvSpPr>
          <p:spPr>
            <a:xfrm>
              <a:off x="6136956" y="5318211"/>
              <a:ext cx="424780" cy="15172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8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7 (15)</a:t>
              </a:r>
            </a:p>
          </p:txBody>
        </p:sp>
        <p:sp>
          <p:nvSpPr>
            <p:cNvPr id="69" name="tx10"/>
            <p:cNvSpPr/>
            <p:nvPr/>
          </p:nvSpPr>
          <p:spPr>
            <a:xfrm>
              <a:off x="7640571" y="5318211"/>
              <a:ext cx="424780" cy="15172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8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1 (20)</a:t>
              </a:r>
            </a:p>
          </p:txBody>
        </p:sp>
        <p:sp>
          <p:nvSpPr>
            <p:cNvPr id="70" name="pl11"/>
            <p:cNvSpPr/>
            <p:nvPr/>
          </p:nvSpPr>
          <p:spPr>
            <a:xfrm>
              <a:off x="1537777" y="4914529"/>
              <a:ext cx="0" cy="994189"/>
            </a:xfrm>
            <a:custGeom>
              <a:avLst/>
              <a:gdLst/>
              <a:ahLst/>
              <a:cxnLst/>
              <a:rect l="0" t="0" r="0" b="0"/>
              <a:pathLst>
                <a:path h="994189">
                  <a:moveTo>
                    <a:pt x="0" y="994189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12"/>
            <p:cNvSpPr/>
            <p:nvPr/>
          </p:nvSpPr>
          <p:spPr>
            <a:xfrm>
              <a:off x="1499820" y="5411623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13"/>
            <p:cNvSpPr/>
            <p:nvPr/>
          </p:nvSpPr>
          <p:spPr>
            <a:xfrm>
              <a:off x="1537777" y="5908718"/>
              <a:ext cx="6615906" cy="0"/>
            </a:xfrm>
            <a:custGeom>
              <a:avLst/>
              <a:gdLst/>
              <a:ahLst/>
              <a:cxnLst/>
              <a:rect l="0" t="0" r="0" b="0"/>
              <a:pathLst>
                <a:path w="6615906">
                  <a:moveTo>
                    <a:pt x="0" y="0"/>
                  </a:moveTo>
                  <a:lnTo>
                    <a:pt x="6615906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14"/>
            <p:cNvSpPr/>
            <p:nvPr/>
          </p:nvSpPr>
          <p:spPr>
            <a:xfrm>
              <a:off x="1838500" y="59087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15"/>
            <p:cNvSpPr/>
            <p:nvPr/>
          </p:nvSpPr>
          <p:spPr>
            <a:xfrm>
              <a:off x="3342116" y="59087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16"/>
            <p:cNvSpPr/>
            <p:nvPr/>
          </p:nvSpPr>
          <p:spPr>
            <a:xfrm>
              <a:off x="4845731" y="59087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17"/>
            <p:cNvSpPr/>
            <p:nvPr/>
          </p:nvSpPr>
          <p:spPr>
            <a:xfrm>
              <a:off x="6349346" y="59087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18"/>
            <p:cNvSpPr/>
            <p:nvPr/>
          </p:nvSpPr>
          <p:spPr>
            <a:xfrm>
              <a:off x="7852961" y="590871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tx19"/>
            <p:cNvSpPr/>
            <p:nvPr/>
          </p:nvSpPr>
          <p:spPr>
            <a:xfrm>
              <a:off x="1796122" y="5976893"/>
              <a:ext cx="84757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0</a:t>
              </a:r>
            </a:p>
          </p:txBody>
        </p:sp>
        <p:sp>
          <p:nvSpPr>
            <p:cNvPr id="79" name="tx20"/>
            <p:cNvSpPr/>
            <p:nvPr/>
          </p:nvSpPr>
          <p:spPr>
            <a:xfrm>
              <a:off x="3257358" y="5976893"/>
              <a:ext cx="169515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10</a:t>
              </a:r>
            </a:p>
          </p:txBody>
        </p:sp>
        <p:sp>
          <p:nvSpPr>
            <p:cNvPr id="80" name="tx21"/>
            <p:cNvSpPr/>
            <p:nvPr/>
          </p:nvSpPr>
          <p:spPr>
            <a:xfrm>
              <a:off x="4760973" y="5976521"/>
              <a:ext cx="169515" cy="10983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20</a:t>
              </a:r>
            </a:p>
          </p:txBody>
        </p:sp>
        <p:sp>
          <p:nvSpPr>
            <p:cNvPr id="81" name="tx22"/>
            <p:cNvSpPr/>
            <p:nvPr/>
          </p:nvSpPr>
          <p:spPr>
            <a:xfrm>
              <a:off x="6264588" y="5976744"/>
              <a:ext cx="169515" cy="1096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30</a:t>
              </a:r>
            </a:p>
          </p:txBody>
        </p:sp>
        <p:sp>
          <p:nvSpPr>
            <p:cNvPr id="82" name="tx23"/>
            <p:cNvSpPr/>
            <p:nvPr/>
          </p:nvSpPr>
          <p:spPr>
            <a:xfrm>
              <a:off x="7768204" y="5976595"/>
              <a:ext cx="169515" cy="1097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40</a:t>
              </a:r>
            </a:p>
          </p:txBody>
        </p:sp>
        <p:sp>
          <p:nvSpPr>
            <p:cNvPr id="83" name="tx24"/>
            <p:cNvSpPr/>
            <p:nvPr/>
          </p:nvSpPr>
          <p:spPr>
            <a:xfrm>
              <a:off x="4598651" y="6154203"/>
              <a:ext cx="494158" cy="13135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Month</a:t>
              </a:r>
            </a:p>
          </p:txBody>
        </p:sp>
        <p:sp>
          <p:nvSpPr>
            <p:cNvPr id="84" name="tx25"/>
            <p:cNvSpPr/>
            <p:nvPr/>
          </p:nvSpPr>
          <p:spPr>
            <a:xfrm>
              <a:off x="1537777" y="4604060"/>
              <a:ext cx="3094235" cy="1896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600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Number at risk (number censored)</a:t>
              </a:r>
            </a:p>
          </p:txBody>
        </p:sp>
      </p:grpSp>
      <p:sp>
        <p:nvSpPr>
          <p:cNvPr id="85" name="TextBox 84">
            <a:extLst>
              <a:ext uri="{FF2B5EF4-FFF2-40B4-BE49-F238E27FC236}">
                <a16:creationId xmlns:a16="http://schemas.microsoft.com/office/drawing/2014/main" id="{66A35D11-9903-754E-4B8A-F333F8BCBB35}"/>
              </a:ext>
            </a:extLst>
          </p:cNvPr>
          <p:cNvSpPr txBox="1"/>
          <p:nvPr/>
        </p:nvSpPr>
        <p:spPr>
          <a:xfrm>
            <a:off x="539552" y="528650"/>
            <a:ext cx="57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1B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29</Words>
  <Application>Microsoft Macintosh PowerPoint</Application>
  <PresentationFormat>On-screen Show (4:3)</PresentationFormat>
  <Paragraphs>8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Helvetica</vt:lpstr>
      <vt:lpstr>Office Theme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/>
  <cp:keywords/>
  <dc:description/>
  <cp:lastModifiedBy>Elaine Lam - Medical Oncology</cp:lastModifiedBy>
  <cp:revision>9</cp:revision>
  <dcterms:created xsi:type="dcterms:W3CDTF">2017-02-13T16:18:36Z</dcterms:created>
  <dcterms:modified xsi:type="dcterms:W3CDTF">2023-05-16T20:51:08Z</dcterms:modified>
  <cp:category/>
</cp:coreProperties>
</file>